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99"/>
    <a:srgbClr val="008000"/>
    <a:srgbClr val="003366"/>
    <a:srgbClr val="A50021"/>
    <a:srgbClr val="00FF00"/>
    <a:srgbClr val="000000"/>
    <a:srgbClr val="FF0066"/>
    <a:srgbClr val="FF00FF"/>
    <a:srgbClr val="FFFF0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hishek Ojha" userId="253db238782fe597" providerId="LiveId" clId="{91EC92A8-AD95-4AFC-8437-76CF5467771A}"/>
    <pc:docChg chg="undo custSel modSld">
      <pc:chgData name="Abhishek Ojha" userId="253db238782fe597" providerId="LiveId" clId="{91EC92A8-AD95-4AFC-8437-76CF5467771A}" dt="2024-01-29T09:24:01.973" v="2561" actId="164"/>
      <pc:docMkLst>
        <pc:docMk/>
      </pc:docMkLst>
      <pc:sldChg chg="addSp delSp modSp mod">
        <pc:chgData name="Abhishek Ojha" userId="253db238782fe597" providerId="LiveId" clId="{91EC92A8-AD95-4AFC-8437-76CF5467771A}" dt="2024-01-29T06:46:36.444" v="1303" actId="208"/>
        <pc:sldMkLst>
          <pc:docMk/>
          <pc:sldMk cId="3102262495" sldId="256"/>
        </pc:sldMkLst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7" creationId="{7D90D50F-6312-95AA-15CA-A4E82ECF0CCD}"/>
          </ac:spMkLst>
        </pc:spChg>
        <pc:spChg chg="del mod topLvl">
          <ac:chgData name="Abhishek Ojha" userId="253db238782fe597" providerId="LiveId" clId="{91EC92A8-AD95-4AFC-8437-76CF5467771A}" dt="2024-01-29T05:44:39.129" v="939" actId="478"/>
          <ac:spMkLst>
            <pc:docMk/>
            <pc:sldMk cId="3102262495" sldId="256"/>
            <ac:spMk id="13" creationId="{F339E949-0E44-8F96-C76C-C9ACC049CD14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14" creationId="{DDCF209B-58E8-E362-C853-2930D73FBE1B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16" creationId="{35E289FA-1282-92B5-041A-A590D163CC6D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18" creationId="{380E8123-4854-6260-3013-4AE79C42B7D3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19" creationId="{6C4F1CFC-39E1-7E12-1A59-43F239EE92E0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20" creationId="{87CD4F07-3EA7-85FA-5191-6F521EF3D141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21" creationId="{DC42CC58-B5EC-424F-FF15-187D03551FB4}"/>
          </ac:spMkLst>
        </pc:spChg>
        <pc:spChg chg="del mod topLvl">
          <ac:chgData name="Abhishek Ojha" userId="253db238782fe597" providerId="LiveId" clId="{91EC92A8-AD95-4AFC-8437-76CF5467771A}" dt="2024-01-29T05:43:37.843" v="786" actId="478"/>
          <ac:spMkLst>
            <pc:docMk/>
            <pc:sldMk cId="3102262495" sldId="256"/>
            <ac:spMk id="26" creationId="{FB07AE63-0787-648A-6A41-28DAA009681A}"/>
          </ac:spMkLst>
        </pc:spChg>
        <pc:spChg chg="del mod topLvl">
          <ac:chgData name="Abhishek Ojha" userId="253db238782fe597" providerId="LiveId" clId="{91EC92A8-AD95-4AFC-8437-76CF5467771A}" dt="2024-01-29T05:43:41.157" v="787" actId="478"/>
          <ac:spMkLst>
            <pc:docMk/>
            <pc:sldMk cId="3102262495" sldId="256"/>
            <ac:spMk id="28" creationId="{5F1D596E-11E9-4EAB-0B60-C195699BFAAF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0" creationId="{5CAE1A78-DCCD-3855-035F-1330E7C1F662}"/>
          </ac:spMkLst>
        </pc:spChg>
        <pc:spChg chg="del mod topLvl">
          <ac:chgData name="Abhishek Ojha" userId="253db238782fe597" providerId="LiveId" clId="{91EC92A8-AD95-4AFC-8437-76CF5467771A}" dt="2024-01-29T05:42:15.027" v="712" actId="478"/>
          <ac:spMkLst>
            <pc:docMk/>
            <pc:sldMk cId="3102262495" sldId="256"/>
            <ac:spMk id="31" creationId="{B5337C95-D38B-9FCB-AA69-BAB7BF76E3B8}"/>
          </ac:spMkLst>
        </pc:spChg>
        <pc:spChg chg="del mod topLvl">
          <ac:chgData name="Abhishek Ojha" userId="253db238782fe597" providerId="LiveId" clId="{91EC92A8-AD95-4AFC-8437-76CF5467771A}" dt="2024-01-29T05:42:49.694" v="733" actId="478"/>
          <ac:spMkLst>
            <pc:docMk/>
            <pc:sldMk cId="3102262495" sldId="256"/>
            <ac:spMk id="32" creationId="{9B7DB7AC-47B3-1C5B-082F-4BF57C963389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3" creationId="{46456C31-C2C8-6092-0EE6-AB05711B0CFF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4" creationId="{F21A4488-5535-A197-2003-0B026AC98AFF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5" creationId="{8FCDA5A1-6978-DBC8-CF13-1CC161CF9555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6" creationId="{1C50228B-1216-C734-9E51-AA81824982EF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37" creationId="{43B9D8F6-DA6A-430A-678D-A6554A876F71}"/>
          </ac:spMkLst>
        </pc:spChg>
        <pc:spChg chg="del mod topLvl">
          <ac:chgData name="Abhishek Ojha" userId="253db238782fe597" providerId="LiveId" clId="{91EC92A8-AD95-4AFC-8437-76CF5467771A}" dt="2024-01-29T05:42:23.568" v="715" actId="478"/>
          <ac:spMkLst>
            <pc:docMk/>
            <pc:sldMk cId="3102262495" sldId="256"/>
            <ac:spMk id="38" creationId="{8311F067-C6FD-2F33-3997-035D75D5CD63}"/>
          </ac:spMkLst>
        </pc:spChg>
        <pc:spChg chg="mod topLvl">
          <ac:chgData name="Abhishek Ojha" userId="253db238782fe597" providerId="LiveId" clId="{91EC92A8-AD95-4AFC-8437-76CF5467771A}" dt="2024-01-29T05:48:54.727" v="1300" actId="113"/>
          <ac:spMkLst>
            <pc:docMk/>
            <pc:sldMk cId="3102262495" sldId="256"/>
            <ac:spMk id="39" creationId="{48773A7A-1BAA-71E0-D711-5F964A9A8CA1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41" creationId="{D8A226B8-361B-0256-9ACE-DEA16CF707CC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42" creationId="{A73280A6-865F-C6CB-FB8E-4832AC34F7C9}"/>
          </ac:spMkLst>
        </pc:spChg>
        <pc:spChg chg="del mod topLvl">
          <ac:chgData name="Abhishek Ojha" userId="253db238782fe597" providerId="LiveId" clId="{91EC92A8-AD95-4AFC-8437-76CF5467771A}" dt="2024-01-29T05:41:57.004" v="679" actId="478"/>
          <ac:spMkLst>
            <pc:docMk/>
            <pc:sldMk cId="3102262495" sldId="256"/>
            <ac:spMk id="46" creationId="{4EAD997C-3A64-0991-C170-005D75C968A2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47" creationId="{2596C12B-AD20-E259-4150-F8CA6AD4141E}"/>
          </ac:spMkLst>
        </pc:spChg>
        <pc:spChg chg="mod topLvl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49" creationId="{C954B9BE-21D2-CDCF-D2C0-E0727D77E9B3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50" creationId="{9F8AD034-0F97-1FED-75F9-19F26BC6AE8A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53" creationId="{E48C8698-D34B-9557-26FA-BA33F7F8A602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54" creationId="{77EFE8FE-8565-B687-31BB-EC0E8A51AF7A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2" creationId="{103187BC-4220-6972-F0FC-95117A071C65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3" creationId="{8CF34E27-4893-E902-0EC5-0969D3659930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4" creationId="{14CCCA32-1405-576B-0590-7C0B56492499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5" creationId="{343EB270-EC61-03E6-7768-663020679766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6" creationId="{B11065B6-B391-888D-7F7A-734159B7C06D}"/>
          </ac:spMkLst>
        </pc:spChg>
        <pc:spChg chg="mod">
          <ac:chgData name="Abhishek Ojha" userId="253db238782fe597" providerId="LiveId" clId="{91EC92A8-AD95-4AFC-8437-76CF5467771A}" dt="2024-01-29T05:48:43.062" v="1299" actId="1035"/>
          <ac:spMkLst>
            <pc:docMk/>
            <pc:sldMk cId="3102262495" sldId="256"/>
            <ac:spMk id="67" creationId="{4C069897-83DD-ED02-2A01-9DFB3FE743DC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68" creationId="{F4D41692-2A6F-55AC-5171-AE5A12C41704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70" creationId="{96B1A5AF-DB84-41D3-057D-C0A46643389B}"/>
          </ac:spMkLst>
        </pc:spChg>
        <pc:spChg chg="mod">
          <ac:chgData name="Abhishek Ojha" userId="253db238782fe597" providerId="LiveId" clId="{91EC92A8-AD95-4AFC-8437-76CF5467771A}" dt="2024-01-29T05:48:35.377" v="1283" actId="1037"/>
          <ac:spMkLst>
            <pc:docMk/>
            <pc:sldMk cId="3102262495" sldId="256"/>
            <ac:spMk id="71" creationId="{F5BF592D-5213-D530-0EEA-0FFD9A935866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72" creationId="{C57FB6ED-CBC9-1DB0-5121-C508192F5D62}"/>
          </ac:spMkLst>
        </pc:spChg>
        <pc:spChg chg="mod">
          <ac:chgData name="Abhishek Ojha" userId="253db238782fe597" providerId="LiveId" clId="{91EC92A8-AD95-4AFC-8437-76CF5467771A}" dt="2024-01-29T05:48:58.036" v="1301" actId="113"/>
          <ac:spMkLst>
            <pc:docMk/>
            <pc:sldMk cId="3102262495" sldId="256"/>
            <ac:spMk id="73" creationId="{0DC0002A-5B0C-DB2A-E35E-F71CF6098F5F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80" creationId="{2853FA57-BA1A-707A-9708-1FE22FFF53FD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81" creationId="{BB5C1F46-45B2-3F40-EC86-47F8482E7951}"/>
          </ac:spMkLst>
        </pc:spChg>
        <pc:spChg chg="mod">
          <ac:chgData name="Abhishek Ojha" userId="253db238782fe597" providerId="LiveId" clId="{91EC92A8-AD95-4AFC-8437-76CF5467771A}" dt="2024-01-29T05:47:32.463" v="1187" actId="1036"/>
          <ac:spMkLst>
            <pc:docMk/>
            <pc:sldMk cId="3102262495" sldId="256"/>
            <ac:spMk id="82" creationId="{911F1EB3-4D65-94F3-9AC9-FA8CE37DB24A}"/>
          </ac:spMkLst>
        </pc:spChg>
        <pc:grpChg chg="add del mod">
          <ac:chgData name="Abhishek Ojha" userId="253db238782fe597" providerId="LiveId" clId="{91EC92A8-AD95-4AFC-8437-76CF5467771A}" dt="2024-01-29T05:38:18.811" v="373" actId="165"/>
          <ac:grpSpMkLst>
            <pc:docMk/>
            <pc:sldMk cId="3102262495" sldId="256"/>
            <ac:grpSpMk id="2" creationId="{5B21253A-C6C0-37F2-722B-F83E4C931F95}"/>
          </ac:grpSpMkLst>
        </pc:grpChg>
        <pc:grpChg chg="mod topLvl">
          <ac:chgData name="Abhishek Ojha" userId="253db238782fe597" providerId="LiveId" clId="{91EC92A8-AD95-4AFC-8437-76CF5467771A}" dt="2024-01-29T05:47:32.463" v="1187" actId="1036"/>
          <ac:grpSpMkLst>
            <pc:docMk/>
            <pc:sldMk cId="3102262495" sldId="256"/>
            <ac:grpSpMk id="22" creationId="{6B5A5CA9-FADD-B147-36EB-67BC09659B26}"/>
          </ac:grpSpMkLst>
        </pc:grpChg>
        <pc:grpChg chg="mod topLvl">
          <ac:chgData name="Abhishek Ojha" userId="253db238782fe597" providerId="LiveId" clId="{91EC92A8-AD95-4AFC-8437-76CF5467771A}" dt="2024-01-29T05:47:32.463" v="1187" actId="1036"/>
          <ac:grpSpMkLst>
            <pc:docMk/>
            <pc:sldMk cId="3102262495" sldId="256"/>
            <ac:grpSpMk id="24" creationId="{196025EC-5F6F-BBE5-DE13-5B09850DABA5}"/>
          </ac:grpSpMkLst>
        </pc:grpChg>
        <pc:grpChg chg="mod">
          <ac:chgData name="Abhishek Ojha" userId="253db238782fe597" providerId="LiveId" clId="{91EC92A8-AD95-4AFC-8437-76CF5467771A}" dt="2024-01-29T05:47:32.463" v="1187" actId="1036"/>
          <ac:grpSpMkLst>
            <pc:docMk/>
            <pc:sldMk cId="3102262495" sldId="256"/>
            <ac:grpSpMk id="52" creationId="{E93877D5-C6E3-490D-5110-C766D03F85A0}"/>
          </ac:grpSpMkLst>
        </pc:grpChg>
        <pc:grpChg chg="add mod topLvl">
          <ac:chgData name="Abhishek Ojha" userId="253db238782fe597" providerId="LiveId" clId="{91EC92A8-AD95-4AFC-8437-76CF5467771A}" dt="2024-01-29T05:47:32.463" v="1187" actId="1036"/>
          <ac:grpSpMkLst>
            <pc:docMk/>
            <pc:sldMk cId="3102262495" sldId="256"/>
            <ac:grpSpMk id="84" creationId="{F2877601-2769-241D-2AD9-716E82A07630}"/>
          </ac:grpSpMkLst>
        </pc:grpChg>
        <pc:grpChg chg="add del mod">
          <ac:chgData name="Abhishek Ojha" userId="253db238782fe597" providerId="LiveId" clId="{91EC92A8-AD95-4AFC-8437-76CF5467771A}" dt="2024-01-29T05:46:38.553" v="1101" actId="165"/>
          <ac:grpSpMkLst>
            <pc:docMk/>
            <pc:sldMk cId="3102262495" sldId="256"/>
            <ac:grpSpMk id="87" creationId="{175B1B7F-5A83-72B0-07AA-5786DD378F8F}"/>
          </ac:grpSpMkLst>
        </pc:grpChg>
        <pc:grpChg chg="add mod">
          <ac:chgData name="Abhishek Ojha" userId="253db238782fe597" providerId="LiveId" clId="{91EC92A8-AD95-4AFC-8437-76CF5467771A}" dt="2024-01-29T05:47:32.463" v="1187" actId="1036"/>
          <ac:grpSpMkLst>
            <pc:docMk/>
            <pc:sldMk cId="3102262495" sldId="256"/>
            <ac:grpSpMk id="88" creationId="{369D02AE-2CD1-7289-F1B5-0E8811E641CA}"/>
          </ac:grpSpMkLst>
        </pc:grpChg>
        <pc:picChg chg="mod">
          <ac:chgData name="Abhishek Ojha" userId="253db238782fe597" providerId="LiveId" clId="{91EC92A8-AD95-4AFC-8437-76CF5467771A}" dt="2024-01-29T05:47:32.463" v="1187" actId="1036"/>
          <ac:picMkLst>
            <pc:docMk/>
            <pc:sldMk cId="3102262495" sldId="256"/>
            <ac:picMk id="48" creationId="{CE456843-78FE-792A-9D8A-7C02415506AD}"/>
          </ac:picMkLst>
        </pc:picChg>
        <pc:picChg chg="mod">
          <ac:chgData name="Abhishek Ojha" userId="253db238782fe597" providerId="LiveId" clId="{91EC92A8-AD95-4AFC-8437-76CF5467771A}" dt="2024-01-29T05:47:32.463" v="1187" actId="1036"/>
          <ac:picMkLst>
            <pc:docMk/>
            <pc:sldMk cId="3102262495" sldId="256"/>
            <ac:picMk id="61" creationId="{17AFC126-468D-977F-4ED5-BF6D5B99E5DD}"/>
          </ac:picMkLst>
        </pc:pic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3" creationId="{12FF7C96-C532-19AF-1C66-24CDD7171658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4" creationId="{6BA96A6A-0422-A2DC-508D-936178D01ABE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5" creationId="{E27A8AE6-067C-4ED5-B408-5A9CD3B6B2DF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6" creationId="{D45A13AA-7D42-C54B-A577-C4FA7D6B16BC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8" creationId="{7D45B826-C084-D2D8-6D1B-28614F49E539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9" creationId="{A6B72190-4B66-5290-2A0F-F52C4E771437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10" creationId="{F7A8BC16-AF1D-7EB9-6BB2-AE4F6EF33563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11" creationId="{68348030-44FE-387A-40E2-A4E5F50C44EC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12" creationId="{E430701D-AC79-8E46-4FB0-8128ACEA9DE5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15" creationId="{A7641FCF-AC1A-83A7-6D28-F48580032915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17" creationId="{3A3B5AB0-F9FE-9A2A-255C-FD2C0E22195F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23" creationId="{9521D0F5-57DE-DB80-A89A-D8A0D140EC21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25" creationId="{47B6FF33-129A-66DA-C37E-52681C786F5D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27" creationId="{01CDF37B-63DB-07E6-F944-1BDA022000AF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29" creationId="{7087D20D-F754-0D19-FC51-2A1867E8138E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43" creationId="{9C5E80CC-301E-EEB2-4BF3-4B8202BF1F9E}"/>
          </ac:cxnSpMkLst>
        </pc:cxnChg>
        <pc:cxnChg chg="del mod topLvl">
          <ac:chgData name="Abhishek Ojha" userId="253db238782fe597" providerId="LiveId" clId="{91EC92A8-AD95-4AFC-8437-76CF5467771A}" dt="2024-01-29T05:41:59.624" v="680" actId="478"/>
          <ac:cxnSpMkLst>
            <pc:docMk/>
            <pc:sldMk cId="3102262495" sldId="256"/>
            <ac:cxnSpMk id="44" creationId="{A55758D4-C747-C106-DA6E-09BC61168443}"/>
          </ac:cxnSpMkLst>
        </pc:cxnChg>
        <pc:cxnChg chg="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45" creationId="{36093247-3B52-91E7-6C79-07C687F19D04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51" creationId="{6D527AD3-5492-4F85-7CC8-0C909E01AEB3}"/>
          </ac:cxnSpMkLst>
        </pc:cxnChg>
        <pc:cxnChg chg="del mod topLvl">
          <ac:chgData name="Abhishek Ojha" userId="253db238782fe597" providerId="LiveId" clId="{91EC92A8-AD95-4AFC-8437-76CF5467771A}" dt="2024-01-29T05:42:55.086" v="735" actId="478"/>
          <ac:cxnSpMkLst>
            <pc:docMk/>
            <pc:sldMk cId="3102262495" sldId="256"/>
            <ac:cxnSpMk id="55" creationId="{B461153C-A485-42F1-747B-8FDA8E57C0D5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56" creationId="{22E6A618-8722-79BF-B37D-B2AFBA23C4F9}"/>
          </ac:cxnSpMkLst>
        </pc:cxnChg>
        <pc:cxnChg chg="del mod topLvl">
          <ac:chgData name="Abhishek Ojha" userId="253db238782fe597" providerId="LiveId" clId="{91EC92A8-AD95-4AFC-8437-76CF5467771A}" dt="2024-01-29T05:42:52.734" v="734" actId="478"/>
          <ac:cxnSpMkLst>
            <pc:docMk/>
            <pc:sldMk cId="3102262495" sldId="256"/>
            <ac:cxnSpMk id="57" creationId="{38E71166-652A-01F3-3B0F-BC3B7A64083E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58" creationId="{42E48923-46FD-D152-F05E-2EC036EAA934}"/>
          </ac:cxnSpMkLst>
        </pc:cxnChg>
        <pc:cxnChg chg="del mod topLvl">
          <ac:chgData name="Abhishek Ojha" userId="253db238782fe597" providerId="LiveId" clId="{91EC92A8-AD95-4AFC-8437-76CF5467771A}" dt="2024-01-29T05:42:17.178" v="713" actId="478"/>
          <ac:cxnSpMkLst>
            <pc:docMk/>
            <pc:sldMk cId="3102262495" sldId="256"/>
            <ac:cxnSpMk id="59" creationId="{1F5D6908-82B5-8BA1-81B9-3FB389AE79E4}"/>
          </ac:cxnSpMkLst>
        </pc:cxnChg>
        <pc:cxnChg chg="del mod topLvl">
          <ac:chgData name="Abhishek Ojha" userId="253db238782fe597" providerId="LiveId" clId="{91EC92A8-AD95-4AFC-8437-76CF5467771A}" dt="2024-01-29T05:42:19.775" v="714" actId="478"/>
          <ac:cxnSpMkLst>
            <pc:docMk/>
            <pc:sldMk cId="3102262495" sldId="256"/>
            <ac:cxnSpMk id="60" creationId="{15E3C589-F8A8-0CCC-7EE7-A25A0A5F6992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74" creationId="{42F9BDD5-5C47-E8D3-D7C1-A62E310EF907}"/>
          </ac:cxnSpMkLst>
        </pc:cxnChg>
        <pc:cxnChg chg="add 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75" creationId="{725E0F1A-0B79-1DCE-F5A8-7FB01041F622}"/>
          </ac:cxnSpMkLst>
        </pc:cxnChg>
        <pc:cxnChg chg="add mod">
          <ac:chgData name="Abhishek Ojha" userId="253db238782fe597" providerId="LiveId" clId="{91EC92A8-AD95-4AFC-8437-76CF5467771A}" dt="2024-01-29T06:46:36.444" v="1303" actId="208"/>
          <ac:cxnSpMkLst>
            <pc:docMk/>
            <pc:sldMk cId="3102262495" sldId="256"/>
            <ac:cxnSpMk id="76" creationId="{60ED675D-10F2-66DE-8C66-3DF3BD409A9E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77" creationId="{CFEB9E65-FBA1-3A83-4305-20BA1EA91FAC}"/>
          </ac:cxnSpMkLst>
        </pc:cxnChg>
        <pc:cxnChg chg="mod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78" creationId="{CC0FA053-2397-6E07-523C-3000BB91A9F2}"/>
          </ac:cxnSpMkLst>
        </pc:cxnChg>
        <pc:cxnChg chg="add 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79" creationId="{3C3DAB0E-3EB9-4195-66FF-7CBA74B7047A}"/>
          </ac:cxnSpMkLst>
        </pc:cxnChg>
        <pc:cxnChg chg="add mod topLvl">
          <ac:chgData name="Abhishek Ojha" userId="253db238782fe597" providerId="LiveId" clId="{91EC92A8-AD95-4AFC-8437-76CF5467771A}" dt="2024-01-29T06:46:30.039" v="1302" actId="208"/>
          <ac:cxnSpMkLst>
            <pc:docMk/>
            <pc:sldMk cId="3102262495" sldId="256"/>
            <ac:cxnSpMk id="83" creationId="{57F98CE9-CCA2-3C98-330B-A7F8FB1A40D2}"/>
          </ac:cxnSpMkLst>
        </pc:cxnChg>
        <pc:cxnChg chg="add mod topLvl">
          <ac:chgData name="Abhishek Ojha" userId="253db238782fe597" providerId="LiveId" clId="{91EC92A8-AD95-4AFC-8437-76CF5467771A}" dt="2024-01-29T05:47:32.463" v="1187" actId="1036"/>
          <ac:cxnSpMkLst>
            <pc:docMk/>
            <pc:sldMk cId="3102262495" sldId="256"/>
            <ac:cxnSpMk id="86" creationId="{F5773D18-6B5D-74F3-52FC-5D0807BA70EC}"/>
          </ac:cxnSpMkLst>
        </pc:cxnChg>
      </pc:sldChg>
      <pc:sldChg chg="addSp delSp modSp mod">
        <pc:chgData name="Abhishek Ojha" userId="253db238782fe597" providerId="LiveId" clId="{91EC92A8-AD95-4AFC-8437-76CF5467771A}" dt="2024-01-29T09:24:01.973" v="2561" actId="164"/>
        <pc:sldMkLst>
          <pc:docMk/>
          <pc:sldMk cId="2203508659" sldId="257"/>
        </pc:sldMkLst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5" creationId="{DE903627-CD71-10BD-15B9-FD70FFAD1691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6" creationId="{5C9C77B4-6AA0-FD74-D2F6-EE7D3C693113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7" creationId="{2BC99279-49AB-2D1A-5DDB-DBFD8FD827DF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8" creationId="{EFEF62DB-1D39-FEF9-2C83-8BAF4662D8EF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9" creationId="{B35688C7-7392-9E72-7ED3-5CDA695FA28E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10" creationId="{2324F6ED-2638-EC21-4D23-2E2F45538199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11" creationId="{40731FCF-FACB-FB81-2BB9-B94B4DD4D6F7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12" creationId="{4DA172E9-2BD9-078C-04A0-33D02C646CEB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13" creationId="{D2E98C5C-69E7-4FC1-4E59-8EC20FCEB99B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14" creationId="{B46390EA-6D72-5EB4-3A18-50BCD1C863A0}"/>
          </ac:spMkLst>
        </pc:spChg>
        <pc:spChg chg="mod">
          <ac:chgData name="Abhishek Ojha" userId="253db238782fe597" providerId="LiveId" clId="{91EC92A8-AD95-4AFC-8437-76CF5467771A}" dt="2024-01-29T09:22:38.465" v="2373" actId="688"/>
          <ac:spMkLst>
            <pc:docMk/>
            <pc:sldMk cId="2203508659" sldId="257"/>
            <ac:spMk id="23" creationId="{A69A2901-F4E2-A717-7373-22332765164C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24" creationId="{E43DB0A0-7EED-6EC8-A7D2-00FCD1C74BBF}"/>
          </ac:spMkLst>
        </pc:spChg>
        <pc:spChg chg="mod">
          <ac:chgData name="Abhishek Ojha" userId="253db238782fe597" providerId="LiveId" clId="{91EC92A8-AD95-4AFC-8437-76CF5467771A}" dt="2024-01-29T09:22:11.126" v="2366" actId="1076"/>
          <ac:spMkLst>
            <pc:docMk/>
            <pc:sldMk cId="2203508659" sldId="257"/>
            <ac:spMk id="25" creationId="{078F17D3-4CC0-803A-A2A4-DE0FA3CB747E}"/>
          </ac:spMkLst>
        </pc:spChg>
        <pc:spChg chg="mod">
          <ac:chgData name="Abhishek Ojha" userId="253db238782fe597" providerId="LiveId" clId="{91EC92A8-AD95-4AFC-8437-76CF5467771A}" dt="2024-01-29T09:23:03.023" v="2378" actId="1076"/>
          <ac:spMkLst>
            <pc:docMk/>
            <pc:sldMk cId="2203508659" sldId="257"/>
            <ac:spMk id="26" creationId="{5160807D-93ED-4C13-96AC-ED7C469EBAA7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30" creationId="{594E253F-2A2A-B05D-1A15-27963C59354C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31" creationId="{7903CECC-36E2-6F02-412E-2BD67ECB18E4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32" creationId="{36B19DAB-D5ED-07B6-04EA-F0B49EF5EFC7}"/>
          </ac:spMkLst>
        </pc:spChg>
        <pc:spChg chg="mod">
          <ac:chgData name="Abhishek Ojha" userId="253db238782fe597" providerId="LiveId" clId="{91EC92A8-AD95-4AFC-8437-76CF5467771A}" dt="2024-01-29T09:19:52.126" v="1894" actId="165"/>
          <ac:spMkLst>
            <pc:docMk/>
            <pc:sldMk cId="2203508659" sldId="257"/>
            <ac:spMk id="33" creationId="{6BB24B05-675E-8DB6-0736-DDBCDFCE5A7D}"/>
          </ac:spMkLst>
        </pc:spChg>
        <pc:grpChg chg="add del mod">
          <ac:chgData name="Abhishek Ojha" userId="253db238782fe597" providerId="LiveId" clId="{91EC92A8-AD95-4AFC-8437-76CF5467771A}" dt="2024-01-29T09:19:52.126" v="1894" actId="165"/>
          <ac:grpSpMkLst>
            <pc:docMk/>
            <pc:sldMk cId="2203508659" sldId="257"/>
            <ac:grpSpMk id="3" creationId="{06B471CE-C49C-3C9E-4842-7B35EF3D9CC3}"/>
          </ac:grpSpMkLst>
        </pc:grpChg>
        <pc:grpChg chg="add mod">
          <ac:chgData name="Abhishek Ojha" userId="253db238782fe597" providerId="LiveId" clId="{91EC92A8-AD95-4AFC-8437-76CF5467771A}" dt="2024-01-29T09:24:01.973" v="2561" actId="164"/>
          <ac:grpSpMkLst>
            <pc:docMk/>
            <pc:sldMk cId="2203508659" sldId="257"/>
            <ac:grpSpMk id="4" creationId="{8B3F30A5-0DAE-06CA-29B8-3769167CBFAC}"/>
          </ac:grpSpMkLst>
        </pc:grpChg>
        <pc:grpChg chg="mod topLvl">
          <ac:chgData name="Abhishek Ojha" userId="253db238782fe597" providerId="LiveId" clId="{91EC92A8-AD95-4AFC-8437-76CF5467771A}" dt="2024-01-29T09:24:01.973" v="2561" actId="164"/>
          <ac:grpSpMkLst>
            <pc:docMk/>
            <pc:sldMk cId="2203508659" sldId="257"/>
            <ac:grpSpMk id="16" creationId="{A2E38CE2-B420-B59F-DADB-D9C4594CDDA4}"/>
          </ac:grpSpMkLst>
        </pc:grpChg>
        <pc:grpChg chg="mod topLvl">
          <ac:chgData name="Abhishek Ojha" userId="253db238782fe597" providerId="LiveId" clId="{91EC92A8-AD95-4AFC-8437-76CF5467771A}" dt="2024-01-29T09:24:01.973" v="2561" actId="164"/>
          <ac:grpSpMkLst>
            <pc:docMk/>
            <pc:sldMk cId="2203508659" sldId="257"/>
            <ac:grpSpMk id="34" creationId="{ACA5566D-786E-C717-E1B7-FDA817353B0B}"/>
          </ac:grpSpMkLst>
        </pc:grpChg>
        <pc:picChg chg="mod">
          <ac:chgData name="Abhishek Ojha" userId="253db238782fe597" providerId="LiveId" clId="{91EC92A8-AD95-4AFC-8437-76CF5467771A}" dt="2024-01-29T09:19:52.126" v="1894" actId="165"/>
          <ac:picMkLst>
            <pc:docMk/>
            <pc:sldMk cId="2203508659" sldId="257"/>
            <ac:picMk id="15" creationId="{D188D70E-98DA-1B5E-F317-9E35DF0D6992}"/>
          </ac:picMkLst>
        </pc:pic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17" creationId="{8604FA85-9AEB-65FE-F8F5-E0CA17126322}"/>
          </ac:cxnSpMkLst>
        </pc:cxn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18" creationId="{EE4DCB76-10C7-9B82-C136-D5F0D1892E09}"/>
          </ac:cxnSpMkLst>
        </pc:cxn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19" creationId="{F5ECE9A4-2805-CBFF-94F5-B176D65DB5A4}"/>
          </ac:cxnSpMkLst>
        </pc:cxn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20" creationId="{76D614A7-A923-2D32-F01E-13E3D8099600}"/>
          </ac:cxnSpMkLst>
        </pc:cxn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21" creationId="{FE950A49-C818-4B10-13E5-1BC33A34EF28}"/>
          </ac:cxnSpMkLst>
        </pc:cxnChg>
        <pc:cxnChg chg="mod">
          <ac:chgData name="Abhishek Ojha" userId="253db238782fe597" providerId="LiveId" clId="{91EC92A8-AD95-4AFC-8437-76CF5467771A}" dt="2024-01-29T09:19:52.126" v="1894" actId="165"/>
          <ac:cxnSpMkLst>
            <pc:docMk/>
            <pc:sldMk cId="2203508659" sldId="257"/>
            <ac:cxnSpMk id="22" creationId="{FA102FEA-81CE-BEAC-789F-FAD3CDA47A28}"/>
          </ac:cxnSpMkLst>
        </pc:cxnChg>
      </pc:sldChg>
      <pc:sldChg chg="addSp delSp modSp mod">
        <pc:chgData name="Abhishek Ojha" userId="253db238782fe597" providerId="LiveId" clId="{91EC92A8-AD95-4AFC-8437-76CF5467771A}" dt="2024-01-29T07:12:06.153" v="1689" actId="1035"/>
        <pc:sldMkLst>
          <pc:docMk/>
          <pc:sldMk cId="4003813706" sldId="258"/>
        </pc:sldMkLst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" creationId="{41B393BA-D2C0-ECEE-36D1-C0B8E1722649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3" creationId="{0DE25DE5-979B-8A89-13CE-C7C0B7FC800C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4" creationId="{A329CE12-90A1-223B-FEF8-BE4417CACC2B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5" creationId="{1D436C31-3E23-BEA4-A432-5C955C44BA2A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6" creationId="{69369D9E-B120-8633-B1DA-786BAB605D20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7" creationId="{8E2A5201-C395-F917-32F7-3E2F404D9DEC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8" creationId="{5F1B700B-AF02-B25F-E232-EF9A027CB38E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20" creationId="{1B54B609-B894-D78F-3794-AA717F313FB3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21" creationId="{03D1569D-0F2B-7096-DDDA-5B99206FEB1F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22" creationId="{D900B5DB-3BE9-766E-C6B5-20F981D0B798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24" creationId="{8D7F9F14-9B59-6C2E-B19F-2F431B8D0470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26" creationId="{F214834C-602E-C039-A718-C46278220F2B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27" creationId="{AE1C78D8-348B-0E3E-D167-E34FD94AD0D6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31" creationId="{56F82BFE-6171-5837-0ECF-8E8FC4645035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32" creationId="{5D319D5E-DD95-6803-61D7-0C7D6659358B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33" creationId="{982FEBA6-A3CC-2840-3A7A-8ECC65D38F0D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39" creationId="{BEB80EFC-413F-F95D-F304-0E71E4EFE58C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40" creationId="{FF66E99B-0252-F631-4506-4671D3BC6C0F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41" creationId="{B121CB7A-BE68-314B-51D9-229E77552109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45" creationId="{2D31A8DE-1453-E068-ADE4-3571B5F974DA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46" creationId="{CFC7AB07-E2EB-A953-EBF6-FC2C1DE0113B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47" creationId="{2BF79B33-1015-2FFF-7474-EB687278AC86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48" creationId="{0417483C-03ED-1C49-8F04-77D6DDF7521F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49" creationId="{6A755729-C9B8-6366-F590-EDD5D86058A0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0" creationId="{3AA7EBF4-7D18-93E1-EB57-B8B14A4F6D7B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2" creationId="{ADA541FA-F8CF-E74B-D5FF-528874B7F906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3" creationId="{54F97FAB-0DC1-396E-AA80-B3705BB25A76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4" creationId="{34BF82C4-5961-D941-7ADE-E7074F580B45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5" creationId="{059B5905-0863-9992-91D8-2DEECAB87DBD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56" creationId="{5AFE4A5A-43E4-300D-59AE-7648014743E4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0" creationId="{73F19CB6-578B-60B0-98C0-9B6384177FF0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1" creationId="{E97C8039-43FB-0998-785C-126E681D9A4A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2" creationId="{2390CBDE-1F48-AE93-BD32-D25F106862F3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6" creationId="{01C6DEC6-6C56-105E-CC0A-62D41A4AEDB1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7" creationId="{BB135327-9C48-8C8F-93C8-726B782BB6C1}"/>
          </ac:spMkLst>
        </pc:spChg>
        <pc:spChg chg="mod">
          <ac:chgData name="Abhishek Ojha" userId="253db238782fe597" providerId="LiveId" clId="{91EC92A8-AD95-4AFC-8437-76CF5467771A}" dt="2024-01-29T05:37:31.548" v="200" actId="1035"/>
          <ac:spMkLst>
            <pc:docMk/>
            <pc:sldMk cId="4003813706" sldId="258"/>
            <ac:spMk id="68" creationId="{704932BC-C126-53CF-7FCD-D1072E0F8FDC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77" creationId="{039992FF-3C0E-9A38-A0F4-31A5E4414B9D}"/>
          </ac:spMkLst>
        </pc:spChg>
        <pc:spChg chg="del mod">
          <ac:chgData name="Abhishek Ojha" userId="253db238782fe597" providerId="LiveId" clId="{91EC92A8-AD95-4AFC-8437-76CF5467771A}" dt="2024-01-29T07:10:01.895" v="1539" actId="478"/>
          <ac:spMkLst>
            <pc:docMk/>
            <pc:sldMk cId="4003813706" sldId="258"/>
            <ac:spMk id="82" creationId="{7CB96824-F8C0-A35E-2F4D-0FC99C9B11F2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3" creationId="{6C4D2FD8-786A-F130-874D-0F72B9207883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4" creationId="{1DE59E52-9A3D-C4EB-E8CF-604AC68AC760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5" creationId="{A3FF34D1-98E9-B67B-1672-E3D6B31A847F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6" creationId="{7B89FA2C-0C88-6C8E-8D49-BB4D7BEB3B0A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87" creationId="{D0B7B8A9-3684-A261-FC2F-B71729F3A725}"/>
          </ac:spMkLst>
        </pc:spChg>
        <pc:spChg chg="del mod">
          <ac:chgData name="Abhishek Ojha" userId="253db238782fe597" providerId="LiveId" clId="{91EC92A8-AD95-4AFC-8437-76CF5467771A}" dt="2024-01-29T07:09:51.174" v="1537" actId="478"/>
          <ac:spMkLst>
            <pc:docMk/>
            <pc:sldMk cId="4003813706" sldId="258"/>
            <ac:spMk id="89" creationId="{363A2EB1-C1D5-5846-4EFC-AEC049DCA7B5}"/>
          </ac:spMkLst>
        </pc:spChg>
        <pc:spChg chg="del mod">
          <ac:chgData name="Abhishek Ojha" userId="253db238782fe597" providerId="LiveId" clId="{91EC92A8-AD95-4AFC-8437-76CF5467771A}" dt="2024-01-29T07:09:54.473" v="1538" actId="478"/>
          <ac:spMkLst>
            <pc:docMk/>
            <pc:sldMk cId="4003813706" sldId="258"/>
            <ac:spMk id="90" creationId="{F3FF9383-7CE1-AA77-AC3B-44D807D4FFC7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91" creationId="{ACEAA594-459F-F0BE-35D1-EB2930ED37C8}"/>
          </ac:spMkLst>
        </pc:spChg>
        <pc:spChg chg="del mod">
          <ac:chgData name="Abhishek Ojha" userId="253db238782fe597" providerId="LiveId" clId="{91EC92A8-AD95-4AFC-8437-76CF5467771A}" dt="2024-01-29T07:09:36.878" v="1534" actId="478"/>
          <ac:spMkLst>
            <pc:docMk/>
            <pc:sldMk cId="4003813706" sldId="258"/>
            <ac:spMk id="92" creationId="{CD77DB1A-E659-3CCB-08A9-B8155C673F59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93" creationId="{529935CC-446E-A3E0-5B2B-D1E1E765F231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97" creationId="{8FE88360-A699-08E9-F0AF-08B5A504A7C8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98" creationId="{C73749F4-E410-40E5-41EB-8A32F6E3F7F7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99" creationId="{72BED13B-F3D0-0C9D-CA4C-BA35C7A4FE06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03" creationId="{F4B6D9A2-B195-0D15-C864-E11B373CCAA4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04" creationId="{D36A18F2-171C-96E6-2983-EF7A430365A4}"/>
          </ac:spMkLst>
        </pc:spChg>
        <pc:spChg chg="mod">
          <ac:chgData name="Abhishek Ojha" userId="253db238782fe597" providerId="LiveId" clId="{91EC92A8-AD95-4AFC-8437-76CF5467771A}" dt="2024-01-29T07:12:06.153" v="1689" actId="1035"/>
          <ac:spMkLst>
            <pc:docMk/>
            <pc:sldMk cId="4003813706" sldId="258"/>
            <ac:spMk id="105" creationId="{1256FD32-D36D-7FC3-94B3-084F425A8EE7}"/>
          </ac:spMkLst>
        </pc:spChg>
        <pc:grpChg chg="add mod">
          <ac:chgData name="Abhishek Ojha" userId="253db238782fe597" providerId="LiveId" clId="{91EC92A8-AD95-4AFC-8437-76CF5467771A}" dt="2024-01-29T05:37:31.548" v="200" actId="1035"/>
          <ac:grpSpMkLst>
            <pc:docMk/>
            <pc:sldMk cId="4003813706" sldId="258"/>
            <ac:grpSpMk id="2" creationId="{15A16AF9-05C7-8111-D1B6-25C946C4C580}"/>
          </ac:grpSpMkLst>
        </pc:grpChg>
        <pc:grpChg chg="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4" creationId="{FF368FF6-1327-8DB8-DBF2-C9D7D0B0F0AB}"/>
          </ac:grpSpMkLst>
        </pc:grpChg>
        <pc:grpChg chg="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19" creationId="{04CF66FF-AE06-CC17-9674-6F143BC988CE}"/>
          </ac:grpSpMkLst>
        </pc:grpChg>
        <pc:grpChg chg="mod">
          <ac:chgData name="Abhishek Ojha" userId="253db238782fe597" providerId="LiveId" clId="{91EC92A8-AD95-4AFC-8437-76CF5467771A}" dt="2024-01-29T05:37:31.548" v="200" actId="1035"/>
          <ac:grpSpMkLst>
            <pc:docMk/>
            <pc:sldMk cId="4003813706" sldId="258"/>
            <ac:grpSpMk id="51" creationId="{7836C043-92DA-5EE7-02FB-656CB39A6603}"/>
          </ac:grpSpMkLst>
        </pc:grpChg>
        <pc:grpChg chg="add 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70" creationId="{0F319EBD-9E04-892D-BCE2-AFFEA4848868}"/>
          </ac:grpSpMkLst>
        </pc:grpChg>
        <pc:grpChg chg="add 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71" creationId="{FF70D99B-7530-3A0C-4735-EDD19B071BF3}"/>
          </ac:grpSpMkLst>
        </pc:grpChg>
        <pc:grpChg chg="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72" creationId="{D4639EAA-719D-7AC8-9A9F-64321806D54B}"/>
          </ac:grpSpMkLst>
        </pc:grpChg>
        <pc:grpChg chg="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88" creationId="{5D17008A-F505-67BD-33E7-E6306E8B8EA8}"/>
          </ac:grpSpMkLst>
        </pc:grpChg>
        <pc:grpChg chg="add mod">
          <ac:chgData name="Abhishek Ojha" userId="253db238782fe597" providerId="LiveId" clId="{91EC92A8-AD95-4AFC-8437-76CF5467771A}" dt="2024-01-29T07:12:06.153" v="1689" actId="1035"/>
          <ac:grpSpMkLst>
            <pc:docMk/>
            <pc:sldMk cId="4003813706" sldId="258"/>
            <ac:grpSpMk id="107" creationId="{9436B7DA-B62C-D40D-A69C-C650642E517D}"/>
          </ac:grpSpMkLst>
        </pc:grpChg>
        <pc:picChg chg="mod">
          <ac:chgData name="Abhishek Ojha" userId="253db238782fe597" providerId="LiveId" clId="{91EC92A8-AD95-4AFC-8437-76CF5467771A}" dt="2024-01-29T07:12:06.153" v="1689" actId="1035"/>
          <ac:picMkLst>
            <pc:docMk/>
            <pc:sldMk cId="4003813706" sldId="258"/>
            <ac:picMk id="38" creationId="{31622586-077D-0D88-5049-162D7E5713CB}"/>
          </ac:picMkLst>
        </pc:picChg>
        <pc:picChg chg="mod">
          <ac:chgData name="Abhishek Ojha" userId="253db238782fe597" providerId="LiveId" clId="{91EC92A8-AD95-4AFC-8437-76CF5467771A}" dt="2024-01-29T05:37:31.548" v="200" actId="1035"/>
          <ac:picMkLst>
            <pc:docMk/>
            <pc:sldMk cId="4003813706" sldId="258"/>
            <ac:picMk id="65" creationId="{BF1C679F-66B4-285F-1CEF-22E0FD87645B}"/>
          </ac:picMkLst>
        </pc:picChg>
        <pc:picChg chg="mod">
          <ac:chgData name="Abhishek Ojha" userId="253db238782fe597" providerId="LiveId" clId="{91EC92A8-AD95-4AFC-8437-76CF5467771A}" dt="2024-01-29T07:12:06.153" v="1689" actId="1035"/>
          <ac:picMkLst>
            <pc:docMk/>
            <pc:sldMk cId="4003813706" sldId="258"/>
            <ac:picMk id="102" creationId="{7C3728DC-A8B5-1C8E-B0F0-E7654929A110}"/>
          </ac:picMkLst>
        </pc:pic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3" creationId="{487035DE-0F13-EBD9-8125-F24135681406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5" creationId="{61A26C6D-A07F-4C62-EDA0-D7521B7D52C3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6" creationId="{C63D374B-3E71-D2ED-7588-9BD62B5500B5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" creationId="{78F3E368-534F-D612-BCEC-99326B39F14A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9" creationId="{92A6C938-4669-5E80-DB63-7952A9610C54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10" creationId="{BBA591C4-7B4F-48CF-5007-EAB91FA88644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11" creationId="{C745B1FE-581F-C2F1-4094-091EF2C4BD80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12" creationId="{2D5E091C-D8FA-507E-A0BF-3189D0327D9F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23" creationId="{4D961AE0-BF72-94DE-FE5C-9B934B40A035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25" creationId="{A7BFE68F-52ED-C249-0713-4763091CD37A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28" creationId="{3035033B-E6F8-57D2-D421-B8B9CCBA09F2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29" creationId="{419B5DDB-74D2-90DF-9E6F-7F6F8A81B2DF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30" creationId="{3D0AA3E7-ADD3-A171-2F5A-92F3F2762212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34" creationId="{4C333C0E-3FCF-85CC-91F5-2EE69D9CA18B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35" creationId="{D7DA1F7F-96D5-E00A-C8AC-AEB9BFF02614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36" creationId="{8B6B36CD-A838-A8A7-C0AA-6FE1135652F6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37" creationId="{525807D9-4C98-3F51-D761-927A706525F9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43" creationId="{9720148E-8103-A2C2-118B-298F745373EB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44" creationId="{3E9C863E-48FB-8F60-B94E-BD567857BA38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57" creationId="{81A2FA88-6713-E380-5AE8-7427B9B5C1E2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58" creationId="{0A6535C8-47B2-B5A8-7401-B3F01B050FB5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59" creationId="{3D742FC4-20F5-051A-53A9-6A9293831FBA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63" creationId="{63BEE5B9-507A-CA70-42AF-CA0785B75BF8}"/>
          </ac:cxnSpMkLst>
        </pc:cxnChg>
        <pc:cxnChg chg="mod">
          <ac:chgData name="Abhishek Ojha" userId="253db238782fe597" providerId="LiveId" clId="{91EC92A8-AD95-4AFC-8437-76CF5467771A}" dt="2024-01-29T05:37:31.548" v="200" actId="1035"/>
          <ac:cxnSpMkLst>
            <pc:docMk/>
            <pc:sldMk cId="4003813706" sldId="258"/>
            <ac:cxnSpMk id="64" creationId="{013E428D-DEFC-02AD-F657-EF1C9063F42F}"/>
          </ac:cxnSpMkLst>
        </pc:cxnChg>
        <pc:cxnChg chg="add 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69" creationId="{2BA1F8E6-F37E-2B31-A59E-FB74FF4072CF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3" creationId="{F20BC635-2934-D4E5-82F1-7C22533C2F16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4" creationId="{C07C6F68-6D09-D95E-6428-EE0326F044E7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5" creationId="{944952AA-31E5-21F2-2871-306B53E01878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6" creationId="{6EC4C53E-A773-B5F6-85F9-92D5119B126F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8" creationId="{DC0AA8F4-271C-CE39-447F-733A78E39E69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79" creationId="{5965EBD4-58D4-25A5-222C-CABA32A58845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80" creationId="{AC4BD531-3DFC-A141-5982-22ED4AC09A8F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81" creationId="{8CDE400E-CF12-C5B2-459F-5FC5BA4A5465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94" creationId="{F4D8C053-15B6-E7FC-B969-2A7529DCC71C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95" creationId="{6536AF84-FD27-E94A-DCAA-0CCB16333A74}"/>
          </ac:cxnSpMkLst>
        </pc:cxnChg>
        <pc:cxnChg chg="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96" creationId="{16661A1D-3799-EB0B-C9FE-20F0BAF3A5F1}"/>
          </ac:cxnSpMkLst>
        </pc:cxnChg>
        <pc:cxnChg chg="del mod">
          <ac:chgData name="Abhishek Ojha" userId="253db238782fe597" providerId="LiveId" clId="{91EC92A8-AD95-4AFC-8437-76CF5467771A}" dt="2024-01-29T07:09:45.531" v="1536" actId="478"/>
          <ac:cxnSpMkLst>
            <pc:docMk/>
            <pc:sldMk cId="4003813706" sldId="258"/>
            <ac:cxnSpMk id="100" creationId="{8451E1D7-0194-6B47-2CD2-82FFAB5B1ECF}"/>
          </ac:cxnSpMkLst>
        </pc:cxnChg>
        <pc:cxnChg chg="del mod">
          <ac:chgData name="Abhishek Ojha" userId="253db238782fe597" providerId="LiveId" clId="{91EC92A8-AD95-4AFC-8437-76CF5467771A}" dt="2024-01-29T07:09:40.718" v="1535" actId="478"/>
          <ac:cxnSpMkLst>
            <pc:docMk/>
            <pc:sldMk cId="4003813706" sldId="258"/>
            <ac:cxnSpMk id="101" creationId="{642611E7-ACB5-09DD-6AF1-C3384D8F1DF3}"/>
          </ac:cxnSpMkLst>
        </pc:cxnChg>
        <pc:cxnChg chg="add mod">
          <ac:chgData name="Abhishek Ojha" userId="253db238782fe597" providerId="LiveId" clId="{91EC92A8-AD95-4AFC-8437-76CF5467771A}" dt="2024-01-29T07:12:06.153" v="1689" actId="1035"/>
          <ac:cxnSpMkLst>
            <pc:docMk/>
            <pc:sldMk cId="4003813706" sldId="258"/>
            <ac:cxnSpMk id="106" creationId="{AD8A4419-0FC8-1687-2817-294189F1A58A}"/>
          </ac:cxnSpMkLst>
        </pc:cxnChg>
      </pc:sldChg>
    </pc:docChg>
  </pc:docChgLst>
  <pc:docChgLst>
    <pc:chgData name="Abhishek Ojha" userId="253db238782fe597" providerId="LiveId" clId="{5F7C18EA-4A95-4890-AAF9-54ACFAE49105}"/>
    <pc:docChg chg="delSld modSld">
      <pc:chgData name="Abhishek Ojha" userId="253db238782fe597" providerId="LiveId" clId="{5F7C18EA-4A95-4890-AAF9-54ACFAE49105}" dt="2024-02-05T04:13:52.125" v="11" actId="20577"/>
      <pc:docMkLst>
        <pc:docMk/>
      </pc:docMkLst>
      <pc:sldChg chg="del">
        <pc:chgData name="Abhishek Ojha" userId="253db238782fe597" providerId="LiveId" clId="{5F7C18EA-4A95-4890-AAF9-54ACFAE49105}" dt="2024-01-31T05:56:23.859" v="0" actId="47"/>
        <pc:sldMkLst>
          <pc:docMk/>
          <pc:sldMk cId="3102262495" sldId="256"/>
        </pc:sldMkLst>
      </pc:sldChg>
      <pc:sldChg chg="modSp mod">
        <pc:chgData name="Abhishek Ojha" userId="253db238782fe597" providerId="LiveId" clId="{5F7C18EA-4A95-4890-AAF9-54ACFAE49105}" dt="2024-02-05T04:13:52.125" v="11" actId="20577"/>
        <pc:sldMkLst>
          <pc:docMk/>
          <pc:sldMk cId="2203508659" sldId="257"/>
        </pc:sldMkLst>
        <pc:spChg chg="mod">
          <ac:chgData name="Abhishek Ojha" userId="253db238782fe597" providerId="LiveId" clId="{5F7C18EA-4A95-4890-AAF9-54ACFAE49105}" dt="2024-02-05T04:13:41.636" v="9" actId="20577"/>
          <ac:spMkLst>
            <pc:docMk/>
            <pc:sldMk cId="2203508659" sldId="257"/>
            <ac:spMk id="2" creationId="{AADE7433-83B5-8EE3-FBD2-C36CC1AE2328}"/>
          </ac:spMkLst>
        </pc:spChg>
        <pc:spChg chg="mod">
          <ac:chgData name="Abhishek Ojha" userId="253db238782fe597" providerId="LiveId" clId="{5F7C18EA-4A95-4890-AAF9-54ACFAE49105}" dt="2024-02-05T04:13:52.125" v="11" actId="20577"/>
          <ac:spMkLst>
            <pc:docMk/>
            <pc:sldMk cId="2203508659" sldId="257"/>
            <ac:spMk id="33" creationId="{6BB24B05-675E-8DB6-0736-DDBCDFCE5A7D}"/>
          </ac:spMkLst>
        </pc:spChg>
      </pc:sldChg>
      <pc:sldChg chg="del">
        <pc:chgData name="Abhishek Ojha" userId="253db238782fe597" providerId="LiveId" clId="{5F7C18EA-4A95-4890-AAF9-54ACFAE49105}" dt="2024-01-31T05:56:26.065" v="1" actId="47"/>
        <pc:sldMkLst>
          <pc:docMk/>
          <pc:sldMk cId="4003813706" sldId="258"/>
        </pc:sldMkLst>
      </pc:sldChg>
    </pc:docChg>
  </pc:docChgLst>
  <pc:docChgLst>
    <pc:chgData name="Abhishek Ojha" userId="253db238782fe597" providerId="LiveId" clId="{50E9DB38-A714-4105-8D1C-A5E7FB308111}"/>
    <pc:docChg chg="custSel delSld modSld">
      <pc:chgData name="Abhishek Ojha" userId="253db238782fe597" providerId="LiveId" clId="{50E9DB38-A714-4105-8D1C-A5E7FB308111}" dt="2022-07-25T13:38:32.375" v="791" actId="20577"/>
      <pc:docMkLst>
        <pc:docMk/>
      </pc:docMkLst>
      <pc:sldChg chg="addSp delSp modSp mod">
        <pc:chgData name="Abhishek Ojha" userId="253db238782fe597" providerId="LiveId" clId="{50E9DB38-A714-4105-8D1C-A5E7FB308111}" dt="2022-07-18T13:03:26.480" v="741" actId="14100"/>
        <pc:sldMkLst>
          <pc:docMk/>
          <pc:sldMk cId="3102262495" sldId="256"/>
        </pc:sldMkLst>
        <pc:spChg chg="add del">
          <ac:chgData name="Abhishek Ojha" userId="253db238782fe597" providerId="LiveId" clId="{50E9DB38-A714-4105-8D1C-A5E7FB308111}" dt="2022-07-17T12:11:37.174" v="214" actId="478"/>
          <ac:spMkLst>
            <pc:docMk/>
            <pc:sldMk cId="3102262495" sldId="256"/>
            <ac:spMk id="2" creationId="{93B53239-1E24-17CF-6F9A-3033594705F9}"/>
          </ac:spMkLst>
        </pc:spChg>
        <pc:spChg chg="add del mod">
          <ac:chgData name="Abhishek Ojha" userId="253db238782fe597" providerId="LiveId" clId="{50E9DB38-A714-4105-8D1C-A5E7FB308111}" dt="2022-07-17T12:17:40.951" v="252" actId="478"/>
          <ac:spMkLst>
            <pc:docMk/>
            <pc:sldMk cId="3102262495" sldId="256"/>
            <ac:spMk id="3" creationId="{B080F329-772A-427B-A892-AA800ECCDEA7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19" creationId="{6C4F1CFC-39E1-7E12-1A59-43F239EE92E0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34" creationId="{F21A4488-5535-A197-2003-0B026AC98AFF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35" creationId="{8FCDA5A1-6978-DBC8-CF13-1CC161CF9555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36" creationId="{1C50228B-1216-C734-9E51-AA81824982EF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37" creationId="{43B9D8F6-DA6A-430A-678D-A6554A876F71}"/>
          </ac:spMkLst>
        </pc:spChg>
        <pc:spChg chg="add mod">
          <ac:chgData name="Abhishek Ojha" userId="253db238782fe597" providerId="LiveId" clId="{50E9DB38-A714-4105-8D1C-A5E7FB308111}" dt="2022-07-17T11:42:01.937" v="51" actId="14100"/>
          <ac:spMkLst>
            <pc:docMk/>
            <pc:sldMk cId="3102262495" sldId="256"/>
            <ac:spMk id="40" creationId="{453E207A-2618-8092-07C6-8B0AB48D1284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41" creationId="{D8A226B8-361B-0256-9ACE-DEA16CF707CC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42" creationId="{A73280A6-865F-C6CB-FB8E-4832AC34F7C9}"/>
          </ac:spMkLst>
        </pc:spChg>
        <pc:spChg chg="add del mod">
          <ac:chgData name="Abhishek Ojha" userId="253db238782fe597" providerId="LiveId" clId="{50E9DB38-A714-4105-8D1C-A5E7FB308111}" dt="2022-07-17T12:13:32.372" v="242" actId="478"/>
          <ac:spMkLst>
            <pc:docMk/>
            <pc:sldMk cId="3102262495" sldId="256"/>
            <ac:spMk id="43" creationId="{EBBE482F-01E0-14F6-4893-E25A4FA080DB}"/>
          </ac:spMkLst>
        </pc:spChg>
        <pc:spChg chg="add del mod">
          <ac:chgData name="Abhishek Ojha" userId="253db238782fe597" providerId="LiveId" clId="{50E9DB38-A714-4105-8D1C-A5E7FB308111}" dt="2022-07-17T12:13:15.982" v="216" actId="478"/>
          <ac:spMkLst>
            <pc:docMk/>
            <pc:sldMk cId="3102262495" sldId="256"/>
            <ac:spMk id="44" creationId="{4E2C0B31-6B94-403B-832A-B6E817CA92B7}"/>
          </ac:spMkLst>
        </pc:spChg>
        <pc:spChg chg="mod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50" creationId="{9F8AD034-0F97-1FED-75F9-19F26BC6AE8A}"/>
          </ac:spMkLst>
        </pc:spChg>
        <pc:spChg chg="mod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53" creationId="{E48C8698-D34B-9557-26FA-BA33F7F8A602}"/>
          </ac:spMkLst>
        </pc:spChg>
        <pc:spChg chg="mod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54" creationId="{77EFE8FE-8565-B687-31BB-EC0E8A51AF7A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65" creationId="{343EB270-EC61-03E6-7768-663020679766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66" creationId="{B11065B6-B391-888D-7F7A-734159B7C06D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67" creationId="{4C069897-83DD-ED02-2A01-9DFB3FE743DC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68" creationId="{F4D41692-2A6F-55AC-5171-AE5A12C41704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70" creationId="{96B1A5AF-DB84-41D3-057D-C0A46643389B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71" creationId="{F5BF592D-5213-D530-0EEA-0FFD9A935866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72" creationId="{C57FB6ED-CBC9-1DB0-5121-C508192F5D62}"/>
          </ac:spMkLst>
        </pc:spChg>
        <pc:spChg chg="mod topLvl">
          <ac:chgData name="Abhishek Ojha" userId="253db238782fe597" providerId="LiveId" clId="{50E9DB38-A714-4105-8D1C-A5E7FB308111}" dt="2022-07-18T13:03:26.480" v="741" actId="14100"/>
          <ac:spMkLst>
            <pc:docMk/>
            <pc:sldMk cId="3102262495" sldId="256"/>
            <ac:spMk id="73" creationId="{0DC0002A-5B0C-DB2A-E35E-F71CF6098F5F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80" creationId="{2853FA57-BA1A-707A-9708-1FE22FFF53FD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81" creationId="{BB5C1F46-45B2-3F40-EC86-47F8482E7951}"/>
          </ac:spMkLst>
        </pc:spChg>
        <pc:spChg chg="mod topLvl">
          <ac:chgData name="Abhishek Ojha" userId="253db238782fe597" providerId="LiveId" clId="{50E9DB38-A714-4105-8D1C-A5E7FB308111}" dt="2022-07-18T12:56:48.383" v="726" actId="1037"/>
          <ac:spMkLst>
            <pc:docMk/>
            <pc:sldMk cId="3102262495" sldId="256"/>
            <ac:spMk id="82" creationId="{911F1EB3-4D65-94F3-9AC9-FA8CE37DB24A}"/>
          </ac:spMkLst>
        </pc:spChg>
        <pc:grpChg chg="add del mod">
          <ac:chgData name="Abhishek Ojha" userId="253db238782fe597" providerId="LiveId" clId="{50E9DB38-A714-4105-8D1C-A5E7FB308111}" dt="2022-07-17T12:24:06.287" v="671" actId="165"/>
          <ac:grpSpMkLst>
            <pc:docMk/>
            <pc:sldMk cId="3102262495" sldId="256"/>
            <ac:grpSpMk id="22" creationId="{43448E60-CF45-6BA6-99A9-1AF80AAAC23A}"/>
          </ac:grpSpMkLst>
        </pc:grpChg>
        <pc:grpChg chg="add mod">
          <ac:chgData name="Abhishek Ojha" userId="253db238782fe597" providerId="LiveId" clId="{50E9DB38-A714-4105-8D1C-A5E7FB308111}" dt="2022-07-18T12:56:48.383" v="726" actId="1037"/>
          <ac:grpSpMkLst>
            <pc:docMk/>
            <pc:sldMk cId="3102262495" sldId="256"/>
            <ac:grpSpMk id="24" creationId="{196025EC-5F6F-BBE5-DE13-5B09850DABA5}"/>
          </ac:grpSpMkLst>
        </pc:grpChg>
        <pc:grpChg chg="mod topLvl">
          <ac:chgData name="Abhishek Ojha" userId="253db238782fe597" providerId="LiveId" clId="{50E9DB38-A714-4105-8D1C-A5E7FB308111}" dt="2022-07-18T12:56:48.383" v="726" actId="1037"/>
          <ac:grpSpMkLst>
            <pc:docMk/>
            <pc:sldMk cId="3102262495" sldId="256"/>
            <ac:grpSpMk id="52" creationId="{E93877D5-C6E3-490D-5110-C766D03F85A0}"/>
          </ac:grpSpMkLst>
        </pc:grpChg>
        <pc:grpChg chg="del mod topLvl">
          <ac:chgData name="Abhishek Ojha" userId="253db238782fe597" providerId="LiveId" clId="{50E9DB38-A714-4105-8D1C-A5E7FB308111}" dt="2022-07-17T12:24:13.205" v="672" actId="165"/>
          <ac:grpSpMkLst>
            <pc:docMk/>
            <pc:sldMk cId="3102262495" sldId="256"/>
            <ac:grpSpMk id="83" creationId="{91D1C042-F5A2-2F01-B1EC-70366F6F2077}"/>
          </ac:grpSpMkLst>
        </pc:grpChg>
        <pc:grpChg chg="del">
          <ac:chgData name="Abhishek Ojha" userId="253db238782fe597" providerId="LiveId" clId="{50E9DB38-A714-4105-8D1C-A5E7FB308111}" dt="2022-07-17T12:13:12.283" v="215" actId="478"/>
          <ac:grpSpMkLst>
            <pc:docMk/>
            <pc:sldMk cId="3102262495" sldId="256"/>
            <ac:grpSpMk id="105" creationId="{9FDDACFC-3982-7311-D939-8B373B0C5469}"/>
          </ac:grpSpMkLst>
        </pc:grpChg>
        <pc:picChg chg="mod">
          <ac:chgData name="Abhishek Ojha" userId="253db238782fe597" providerId="LiveId" clId="{50E9DB38-A714-4105-8D1C-A5E7FB308111}" dt="2022-07-18T12:56:48.383" v="726" actId="1037"/>
          <ac:picMkLst>
            <pc:docMk/>
            <pc:sldMk cId="3102262495" sldId="256"/>
            <ac:picMk id="48" creationId="{CE456843-78FE-792A-9D8A-7C02415506AD}"/>
          </ac:picMkLst>
        </pc:picChg>
        <pc:cxnChg chg="add 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5" creationId="{E27A8AE6-067C-4ED5-B408-5A9CD3B6B2DF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10" creationId="{F7A8BC16-AF1D-7EB9-6BB2-AE4F6EF33563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15" creationId="{A7641FCF-AC1A-83A7-6D28-F48580032915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17" creationId="{3A3B5AB0-F9FE-9A2A-255C-FD2C0E22195F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23" creationId="{9521D0F5-57DE-DB80-A89A-D8A0D140EC21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25" creationId="{47B6FF33-129A-66DA-C37E-52681C786F5D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27" creationId="{01CDF37B-63DB-07E6-F944-1BDA022000AF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29" creationId="{7087D20D-F754-0D19-FC51-2A1867E8138E}"/>
          </ac:cxnSpMkLst>
        </pc:cxnChg>
        <pc:cxnChg chg="add 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51" creationId="{6D527AD3-5492-4F85-7CC8-0C909E01AEB3}"/>
          </ac:cxnSpMkLst>
        </pc:cxnChg>
        <pc:cxnChg chg="add 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56" creationId="{22E6A618-8722-79BF-B37D-B2AFBA23C4F9}"/>
          </ac:cxnSpMkLst>
        </pc:cxnChg>
        <pc:cxnChg chg="add 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58" creationId="{42E48923-46FD-D152-F05E-2EC036EAA934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74" creationId="{42F9BDD5-5C47-E8D3-D7C1-A62E310EF907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77" creationId="{CFEB9E65-FBA1-3A83-4305-20BA1EA91FAC}"/>
          </ac:cxnSpMkLst>
        </pc:cxnChg>
        <pc:cxnChg chg="mod topLvl">
          <ac:chgData name="Abhishek Ojha" userId="253db238782fe597" providerId="LiveId" clId="{50E9DB38-A714-4105-8D1C-A5E7FB308111}" dt="2022-07-18T12:56:48.383" v="726" actId="1037"/>
          <ac:cxnSpMkLst>
            <pc:docMk/>
            <pc:sldMk cId="3102262495" sldId="256"/>
            <ac:cxnSpMk id="78" creationId="{CC0FA053-2397-6E07-523C-3000BB91A9F2}"/>
          </ac:cxnSpMkLst>
        </pc:cxnChg>
      </pc:sldChg>
      <pc:sldChg chg="modSp mod">
        <pc:chgData name="Abhishek Ojha" userId="253db238782fe597" providerId="LiveId" clId="{50E9DB38-A714-4105-8D1C-A5E7FB308111}" dt="2022-07-20T12:47:10.204" v="789" actId="20577"/>
        <pc:sldMkLst>
          <pc:docMk/>
          <pc:sldMk cId="2203508659" sldId="257"/>
        </pc:sldMkLst>
        <pc:spChg chg="mod">
          <ac:chgData name="Abhishek Ojha" userId="253db238782fe597" providerId="LiveId" clId="{50E9DB38-A714-4105-8D1C-A5E7FB308111}" dt="2022-07-20T12:07:33.285" v="745" actId="20577"/>
          <ac:spMkLst>
            <pc:docMk/>
            <pc:sldMk cId="2203508659" sldId="257"/>
            <ac:spMk id="6" creationId="{5C9C77B4-6AA0-FD74-D2F6-EE7D3C693113}"/>
          </ac:spMkLst>
        </pc:spChg>
        <pc:spChg chg="mod">
          <ac:chgData name="Abhishek Ojha" userId="253db238782fe597" providerId="LiveId" clId="{50E9DB38-A714-4105-8D1C-A5E7FB308111}" dt="2022-07-20T12:08:08.748" v="749" actId="20577"/>
          <ac:spMkLst>
            <pc:docMk/>
            <pc:sldMk cId="2203508659" sldId="257"/>
            <ac:spMk id="8" creationId="{EFEF62DB-1D39-FEF9-2C83-8BAF4662D8EF}"/>
          </ac:spMkLst>
        </pc:spChg>
        <pc:spChg chg="mod">
          <ac:chgData name="Abhishek Ojha" userId="253db238782fe597" providerId="LiveId" clId="{50E9DB38-A714-4105-8D1C-A5E7FB308111}" dt="2022-07-20T12:08:22.207" v="751" actId="20577"/>
          <ac:spMkLst>
            <pc:docMk/>
            <pc:sldMk cId="2203508659" sldId="257"/>
            <ac:spMk id="9" creationId="{B35688C7-7392-9E72-7ED3-5CDA695FA28E}"/>
          </ac:spMkLst>
        </pc:spChg>
        <pc:spChg chg="mod">
          <ac:chgData name="Abhishek Ojha" userId="253db238782fe597" providerId="LiveId" clId="{50E9DB38-A714-4105-8D1C-A5E7FB308111}" dt="2022-07-20T12:07:25.707" v="743" actId="20577"/>
          <ac:spMkLst>
            <pc:docMk/>
            <pc:sldMk cId="2203508659" sldId="257"/>
            <ac:spMk id="11" creationId="{40731FCF-FACB-FB81-2BB9-B94B4DD4D6F7}"/>
          </ac:spMkLst>
        </pc:spChg>
        <pc:spChg chg="mod">
          <ac:chgData name="Abhishek Ojha" userId="253db238782fe597" providerId="LiveId" clId="{50E9DB38-A714-4105-8D1C-A5E7FB308111}" dt="2022-07-20T12:07:57.391" v="747" actId="20577"/>
          <ac:spMkLst>
            <pc:docMk/>
            <pc:sldMk cId="2203508659" sldId="257"/>
            <ac:spMk id="12" creationId="{4DA172E9-2BD9-078C-04A0-33D02C646CEB}"/>
          </ac:spMkLst>
        </pc:spChg>
        <pc:spChg chg="mod">
          <ac:chgData name="Abhishek Ojha" userId="253db238782fe597" providerId="LiveId" clId="{50E9DB38-A714-4105-8D1C-A5E7FB308111}" dt="2022-07-20T12:47:10.204" v="789" actId="20577"/>
          <ac:spMkLst>
            <pc:docMk/>
            <pc:sldMk cId="2203508659" sldId="257"/>
            <ac:spMk id="23" creationId="{A69A2901-F4E2-A717-7373-22332765164C}"/>
          </ac:spMkLst>
        </pc:spChg>
        <pc:spChg chg="mod">
          <ac:chgData name="Abhishek Ojha" userId="253db238782fe597" providerId="LiveId" clId="{50E9DB38-A714-4105-8D1C-A5E7FB308111}" dt="2022-07-20T12:42:07.928" v="785" actId="1038"/>
          <ac:spMkLst>
            <pc:docMk/>
            <pc:sldMk cId="2203508659" sldId="257"/>
            <ac:spMk id="31" creationId="{7903CECC-36E2-6F02-412E-2BD67ECB18E4}"/>
          </ac:spMkLst>
        </pc:spChg>
      </pc:sldChg>
      <pc:sldChg chg="modSp del mod">
        <pc:chgData name="Abhishek Ojha" userId="253db238782fe597" providerId="LiveId" clId="{50E9DB38-A714-4105-8D1C-A5E7FB308111}" dt="2022-07-17T11:49:00.494" v="212" actId="47"/>
        <pc:sldMkLst>
          <pc:docMk/>
          <pc:sldMk cId="3091088890" sldId="257"/>
        </pc:sldMkLst>
        <pc:spChg chg="mod">
          <ac:chgData name="Abhishek Ojha" userId="253db238782fe597" providerId="LiveId" clId="{50E9DB38-A714-4105-8D1C-A5E7FB308111}" dt="2022-07-17T11:41:39.156" v="33" actId="1038"/>
          <ac:spMkLst>
            <pc:docMk/>
            <pc:sldMk cId="3091088890" sldId="257"/>
            <ac:spMk id="41" creationId="{3E3B21B6-CB8E-AEFF-A9B0-771EAD551EB4}"/>
          </ac:spMkLst>
        </pc:spChg>
      </pc:sldChg>
      <pc:sldChg chg="modSp mod">
        <pc:chgData name="Abhishek Ojha" userId="253db238782fe597" providerId="LiveId" clId="{50E9DB38-A714-4105-8D1C-A5E7FB308111}" dt="2022-07-25T13:38:32.375" v="791" actId="20577"/>
        <pc:sldMkLst>
          <pc:docMk/>
          <pc:sldMk cId="4003813706" sldId="258"/>
        </pc:sldMkLst>
        <pc:spChg chg="mod">
          <ac:chgData name="Abhishek Ojha" userId="253db238782fe597" providerId="LiveId" clId="{50E9DB38-A714-4105-8D1C-A5E7FB308111}" dt="2022-07-25T13:38:32.375" v="791" actId="20577"/>
          <ac:spMkLst>
            <pc:docMk/>
            <pc:sldMk cId="4003813706" sldId="258"/>
            <ac:spMk id="42" creationId="{C7926686-5ED4-47E8-FBA7-BF05311322AF}"/>
          </ac:spMkLst>
        </pc:spChg>
      </pc:sldChg>
    </pc:docChg>
  </pc:docChgLst>
  <pc:docChgLst>
    <pc:chgData name="Abhishek Ojha" userId="253db238782fe597" providerId="LiveId" clId="{1B07EED7-AA76-48D4-825C-1F714EDEB881}"/>
    <pc:docChg chg="modSld">
      <pc:chgData name="Abhishek Ojha" userId="253db238782fe597" providerId="LiveId" clId="{1B07EED7-AA76-48D4-825C-1F714EDEB881}" dt="2023-02-23T06:04:13.987" v="2" actId="20577"/>
      <pc:docMkLst>
        <pc:docMk/>
      </pc:docMkLst>
      <pc:sldChg chg="addSp modSp mod">
        <pc:chgData name="Abhishek Ojha" userId="253db238782fe597" providerId="LiveId" clId="{1B07EED7-AA76-48D4-825C-1F714EDEB881}" dt="2023-02-23T06:04:13.987" v="2" actId="20577"/>
        <pc:sldMkLst>
          <pc:docMk/>
          <pc:sldMk cId="2203508659" sldId="257"/>
        </pc:sldMkLst>
        <pc:spChg chg="add mod">
          <ac:chgData name="Abhishek Ojha" userId="253db238782fe597" providerId="LiveId" clId="{1B07EED7-AA76-48D4-825C-1F714EDEB881}" dt="2023-02-23T06:04:13.987" v="2" actId="20577"/>
          <ac:spMkLst>
            <pc:docMk/>
            <pc:sldMk cId="2203508659" sldId="257"/>
            <ac:spMk id="2" creationId="{AADE7433-83B5-8EE3-FBD2-C36CC1AE2328}"/>
          </ac:spMkLst>
        </pc:spChg>
      </pc:sldChg>
    </pc:docChg>
  </pc:docChgLst>
  <pc:docChgLst>
    <pc:chgData name="Abhishek Ojha" userId="253db238782fe597" providerId="LiveId" clId="{C17BC266-B65E-4654-BEA1-6DC6C74A6334}"/>
    <pc:docChg chg="modSld">
      <pc:chgData name="Abhishek Ojha" userId="253db238782fe597" providerId="LiveId" clId="{C17BC266-B65E-4654-BEA1-6DC6C74A6334}" dt="2024-01-31T05:55:13.304" v="9" actId="1036"/>
      <pc:docMkLst>
        <pc:docMk/>
      </pc:docMkLst>
      <pc:sldChg chg="modSp">
        <pc:chgData name="Abhishek Ojha" userId="253db238782fe597" providerId="LiveId" clId="{C17BC266-B65E-4654-BEA1-6DC6C74A6334}" dt="2024-01-31T05:55:13.304" v="9" actId="1036"/>
        <pc:sldMkLst>
          <pc:docMk/>
          <pc:sldMk cId="3102262495" sldId="256"/>
        </pc:sldMkLst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7" creationId="{7D90D50F-6312-95AA-15CA-A4E82ECF0CCD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14" creationId="{DDCF209B-58E8-E362-C853-2930D73FBE1B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16" creationId="{35E289FA-1282-92B5-041A-A590D163CC6D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18" creationId="{380E8123-4854-6260-3013-4AE79C42B7D3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19" creationId="{6C4F1CFC-39E1-7E12-1A59-43F239EE92E0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20" creationId="{87CD4F07-3EA7-85FA-5191-6F521EF3D141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21" creationId="{DC42CC58-B5EC-424F-FF15-187D03551FB4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0" creationId="{5CAE1A78-DCCD-3855-035F-1330E7C1F662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3" creationId="{46456C31-C2C8-6092-0EE6-AB05711B0CFF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4" creationId="{F21A4488-5535-A197-2003-0B026AC98AFF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5" creationId="{8FCDA5A1-6978-DBC8-CF13-1CC161CF9555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6" creationId="{1C50228B-1216-C734-9E51-AA81824982EF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7" creationId="{43B9D8F6-DA6A-430A-678D-A6554A876F71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39" creationId="{48773A7A-1BAA-71E0-D711-5F964A9A8CA1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41" creationId="{D8A226B8-361B-0256-9ACE-DEA16CF707CC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42" creationId="{A73280A6-865F-C6CB-FB8E-4832AC34F7C9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47" creationId="{2596C12B-AD20-E259-4150-F8CA6AD4141E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49" creationId="{C954B9BE-21D2-CDCF-D2C0-E0727D77E9B3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50" creationId="{9F8AD034-0F97-1FED-75F9-19F26BC6AE8A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53" creationId="{E48C8698-D34B-9557-26FA-BA33F7F8A602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54" creationId="{77EFE8FE-8565-B687-31BB-EC0E8A51AF7A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2" creationId="{103187BC-4220-6972-F0FC-95117A071C65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3" creationId="{8CF34E27-4893-E902-0EC5-0969D3659930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4" creationId="{14CCCA32-1405-576B-0590-7C0B56492499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5" creationId="{343EB270-EC61-03E6-7768-663020679766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6" creationId="{B11065B6-B391-888D-7F7A-734159B7C06D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7" creationId="{4C069897-83DD-ED02-2A01-9DFB3FE743DC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68" creationId="{F4D41692-2A6F-55AC-5171-AE5A12C41704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70" creationId="{96B1A5AF-DB84-41D3-057D-C0A46643389B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71" creationId="{F5BF592D-5213-D530-0EEA-0FFD9A935866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72" creationId="{C57FB6ED-CBC9-1DB0-5121-C508192F5D62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73" creationId="{0DC0002A-5B0C-DB2A-E35E-F71CF6098F5F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80" creationId="{2853FA57-BA1A-707A-9708-1FE22FFF53FD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81" creationId="{BB5C1F46-45B2-3F40-EC86-47F8482E7951}"/>
          </ac:spMkLst>
        </pc:spChg>
        <pc:spChg chg="mod">
          <ac:chgData name="Abhishek Ojha" userId="253db238782fe597" providerId="LiveId" clId="{C17BC266-B65E-4654-BEA1-6DC6C74A6334}" dt="2024-01-31T05:55:13.304" v="9" actId="1036"/>
          <ac:spMkLst>
            <pc:docMk/>
            <pc:sldMk cId="3102262495" sldId="256"/>
            <ac:spMk id="82" creationId="{911F1EB3-4D65-94F3-9AC9-FA8CE37DB24A}"/>
          </ac:spMkLst>
        </pc:spChg>
        <pc:grpChg chg="mod">
          <ac:chgData name="Abhishek Ojha" userId="253db238782fe597" providerId="LiveId" clId="{C17BC266-B65E-4654-BEA1-6DC6C74A6334}" dt="2024-01-31T05:55:13.304" v="9" actId="1036"/>
          <ac:grpSpMkLst>
            <pc:docMk/>
            <pc:sldMk cId="3102262495" sldId="256"/>
            <ac:grpSpMk id="22" creationId="{6B5A5CA9-FADD-B147-36EB-67BC09659B26}"/>
          </ac:grpSpMkLst>
        </pc:grpChg>
        <pc:grpChg chg="mod">
          <ac:chgData name="Abhishek Ojha" userId="253db238782fe597" providerId="LiveId" clId="{C17BC266-B65E-4654-BEA1-6DC6C74A6334}" dt="2024-01-31T05:55:13.304" v="9" actId="1036"/>
          <ac:grpSpMkLst>
            <pc:docMk/>
            <pc:sldMk cId="3102262495" sldId="256"/>
            <ac:grpSpMk id="24" creationId="{196025EC-5F6F-BBE5-DE13-5B09850DABA5}"/>
          </ac:grpSpMkLst>
        </pc:grpChg>
        <pc:grpChg chg="mod">
          <ac:chgData name="Abhishek Ojha" userId="253db238782fe597" providerId="LiveId" clId="{C17BC266-B65E-4654-BEA1-6DC6C74A6334}" dt="2024-01-31T05:55:13.304" v="9" actId="1036"/>
          <ac:grpSpMkLst>
            <pc:docMk/>
            <pc:sldMk cId="3102262495" sldId="256"/>
            <ac:grpSpMk id="52" creationId="{E93877D5-C6E3-490D-5110-C766D03F85A0}"/>
          </ac:grpSpMkLst>
        </pc:grpChg>
        <pc:grpChg chg="mod">
          <ac:chgData name="Abhishek Ojha" userId="253db238782fe597" providerId="LiveId" clId="{C17BC266-B65E-4654-BEA1-6DC6C74A6334}" dt="2024-01-31T05:55:13.304" v="9" actId="1036"/>
          <ac:grpSpMkLst>
            <pc:docMk/>
            <pc:sldMk cId="3102262495" sldId="256"/>
            <ac:grpSpMk id="84" creationId="{F2877601-2769-241D-2AD9-716E82A07630}"/>
          </ac:grpSpMkLst>
        </pc:grpChg>
        <pc:grpChg chg="mod">
          <ac:chgData name="Abhishek Ojha" userId="253db238782fe597" providerId="LiveId" clId="{C17BC266-B65E-4654-BEA1-6DC6C74A6334}" dt="2024-01-31T05:55:13.304" v="9" actId="1036"/>
          <ac:grpSpMkLst>
            <pc:docMk/>
            <pc:sldMk cId="3102262495" sldId="256"/>
            <ac:grpSpMk id="88" creationId="{369D02AE-2CD1-7289-F1B5-0E8811E641CA}"/>
          </ac:grpSpMkLst>
        </pc:grpChg>
        <pc:picChg chg="mod">
          <ac:chgData name="Abhishek Ojha" userId="253db238782fe597" providerId="LiveId" clId="{C17BC266-B65E-4654-BEA1-6DC6C74A6334}" dt="2024-01-31T05:55:13.304" v="9" actId="1036"/>
          <ac:picMkLst>
            <pc:docMk/>
            <pc:sldMk cId="3102262495" sldId="256"/>
            <ac:picMk id="48" creationId="{CE456843-78FE-792A-9D8A-7C02415506AD}"/>
          </ac:picMkLst>
        </pc:picChg>
        <pc:picChg chg="mod">
          <ac:chgData name="Abhishek Ojha" userId="253db238782fe597" providerId="LiveId" clId="{C17BC266-B65E-4654-BEA1-6DC6C74A6334}" dt="2024-01-31T05:55:13.304" v="9" actId="1036"/>
          <ac:picMkLst>
            <pc:docMk/>
            <pc:sldMk cId="3102262495" sldId="256"/>
            <ac:picMk id="61" creationId="{17AFC126-468D-977F-4ED5-BF6D5B99E5DD}"/>
          </ac:picMkLst>
        </pc:pic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3" creationId="{12FF7C96-C532-19AF-1C66-24CDD7171658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4" creationId="{6BA96A6A-0422-A2DC-508D-936178D01ABE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5" creationId="{E27A8AE6-067C-4ED5-B408-5A9CD3B6B2DF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6" creationId="{D45A13AA-7D42-C54B-A577-C4FA7D6B16BC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8" creationId="{7D45B826-C084-D2D8-6D1B-28614F49E539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9" creationId="{A6B72190-4B66-5290-2A0F-F52C4E771437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10" creationId="{F7A8BC16-AF1D-7EB9-6BB2-AE4F6EF33563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11" creationId="{68348030-44FE-387A-40E2-A4E5F50C44EC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12" creationId="{E430701D-AC79-8E46-4FB0-8128ACEA9DE5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15" creationId="{A7641FCF-AC1A-83A7-6D28-F48580032915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17" creationId="{3A3B5AB0-F9FE-9A2A-255C-FD2C0E22195F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23" creationId="{9521D0F5-57DE-DB80-A89A-D8A0D140EC21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25" creationId="{47B6FF33-129A-66DA-C37E-52681C786F5D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27" creationId="{01CDF37B-63DB-07E6-F944-1BDA022000AF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29" creationId="{7087D20D-F754-0D19-FC51-2A1867E8138E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43" creationId="{9C5E80CC-301E-EEB2-4BF3-4B8202BF1F9E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45" creationId="{36093247-3B52-91E7-6C79-07C687F19D04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51" creationId="{6D527AD3-5492-4F85-7CC8-0C909E01AEB3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56" creationId="{22E6A618-8722-79BF-B37D-B2AFBA23C4F9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58" creationId="{42E48923-46FD-D152-F05E-2EC036EAA934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4" creationId="{42F9BDD5-5C47-E8D3-D7C1-A62E310EF907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5" creationId="{725E0F1A-0B79-1DCE-F5A8-7FB01041F622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6" creationId="{60ED675D-10F2-66DE-8C66-3DF3BD409A9E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7" creationId="{CFEB9E65-FBA1-3A83-4305-20BA1EA91FAC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8" creationId="{CC0FA053-2397-6E07-523C-3000BB91A9F2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79" creationId="{3C3DAB0E-3EB9-4195-66FF-7CBA74B7047A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83" creationId="{57F98CE9-CCA2-3C98-330B-A7F8FB1A40D2}"/>
          </ac:cxnSpMkLst>
        </pc:cxnChg>
        <pc:cxnChg chg="mod">
          <ac:chgData name="Abhishek Ojha" userId="253db238782fe597" providerId="LiveId" clId="{C17BC266-B65E-4654-BEA1-6DC6C74A6334}" dt="2024-01-31T05:55:13.304" v="9" actId="1036"/>
          <ac:cxnSpMkLst>
            <pc:docMk/>
            <pc:sldMk cId="3102262495" sldId="256"/>
            <ac:cxnSpMk id="86" creationId="{F5773D18-6B5D-74F3-52FC-5D0807BA70E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0545C0-6C1A-1FA3-C4AC-8A16CE3428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FA0138-C9AB-FB85-5FE7-1B6BD430CB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54A860-D7C2-9E3F-7DD5-CA0807A9E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5C9E67-9563-6985-8046-AE56106F2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407F4C-7448-616B-F47A-E0D2E5D80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80662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D8EB6-817F-2BF9-1C2A-6A980482D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11BEAB-B60A-27F9-D9DF-737A90187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29FAC2-2853-3066-34A4-13B3FB8ED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0AFB67-FAC6-DDA3-ADF7-63B7318A1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4214D1-3986-8352-C0AD-92A77D9A6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3025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1F758F-5FD6-974D-8E05-AC5C7B127F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F8CA32-37E7-F74D-C448-481E0B30DB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430EC-D423-EC64-A6CD-9238C3FAA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165B5-638E-109B-C06F-FE53D5F59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A69A6-E742-1715-FBB5-5271518AF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5604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98968-18CC-4AF1-037E-FBD9441BE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30050D-5FB9-C813-0EAF-FFA2492B05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BF485-C167-F4A1-FC72-D542FDCC6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606363-A3D3-0C0D-54EC-ECCF539C3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E1CC0-FCA3-F2D8-FBBE-42921C7DB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2966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F132A-37AD-5428-65B3-4563ADB79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441C23-7BF1-6B81-E0AD-901E9ACF7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D69760-7BCB-3F82-2C8B-FD6F0EBD3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8D5646-B00C-DC66-3695-87B453DA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2EB4F-6CBE-46F0-D369-1C74FDBCF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1532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4FD94-EE46-FAC0-1DD9-5D692DCC90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2FADEA-6E42-A725-3070-69C5B51C7E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5C1A53-6DAE-6EAC-2AAF-282C63764D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B56E1E-A34C-8B71-9EB0-6BC8D9C72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F702F9-43F3-0F1A-E3C5-36691E291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2D27C8-CD23-1219-F0CE-1E514667E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7137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5D518-A6C9-507C-1502-20D42701E4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B79D9F-2DB2-4AD5-392C-04C969196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2A7DC5-928D-78E6-5C6C-48966D7C30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FC3B48-903A-4135-1EA5-01E43DE4A9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D1C0F9-B2CF-3227-EC83-67166EDE82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AF3FB4-E9BA-A967-672A-685574E8C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63F398-16B2-C6A9-39FE-A2CCB3BA3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D8E511-4E6B-E281-1201-D6719DA7E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52464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6458A-CA11-6F6F-E2BB-242EC8E0A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78E5EB-1E12-4E76-80B4-1D178AB2C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22FB66-B473-5F19-5B2F-5768DFEA6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2172A9-3D4F-F1D1-3E29-2C347C838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2405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4A6526-6033-F8E2-D0AD-2116F17B4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02997A-EE28-DC3D-5673-318989E2C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38E52A-AC80-DBD9-876C-F5A2E86E2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2708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B1E6E-4603-CF33-0D02-EADC02385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83E270-783B-F849-00A2-316693A182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CA57D6-B33C-E254-6B77-24A3E4292A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1C3ADD-DA5E-5E75-854A-3916E65BF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1C97FF-E8FF-D9E2-083A-639444113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46460-6563-48CB-8018-AEAF51A59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1136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D6221-0B41-6063-8B3B-444F6944A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03F4A8-D6BE-30CC-3477-DA075F8526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420FCC-F7FD-1162-6CA5-0D9893493C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0B4365-FF5A-F3B3-FEC9-CA2572F60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5C4974-61EB-8ACB-20A4-2FC33574F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40762-D4F0-F9D4-D3F4-75F00E8EB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587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29012B-A381-B8E4-C52F-341D68A88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3A04F9-1916-05C9-5AC4-64B11C1AAF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9FFDD3-A831-FFAC-905A-822AB481BD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BF85E-1633-45D6-9846-125792201710}" type="datetimeFigureOut">
              <a:rPr lang="en-IN" smtClean="0"/>
              <a:t>26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9BEE7-0850-1407-6FE3-0AA62F82B6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9D75DB-C879-FD47-387A-93BB03CB16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25772-177F-4DD6-8C12-B8FD85D9133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9753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A2E38CE2-B420-B59F-DADB-D9C4594CDDA4}"/>
              </a:ext>
            </a:extLst>
          </p:cNvPr>
          <p:cNvGrpSpPr/>
          <p:nvPr/>
        </p:nvGrpSpPr>
        <p:grpSpPr>
          <a:xfrm>
            <a:off x="406120" y="593824"/>
            <a:ext cx="11402169" cy="2808312"/>
            <a:chOff x="3977689" y="3429000"/>
            <a:chExt cx="3528392" cy="2808312"/>
          </a:xfrm>
        </p:grpSpPr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8604FA85-9AEB-65FE-F8F5-E0CA17126322}"/>
                </a:ext>
              </a:extLst>
            </p:cNvPr>
            <p:cNvCxnSpPr/>
            <p:nvPr/>
          </p:nvCxnSpPr>
          <p:spPr>
            <a:xfrm>
              <a:off x="3995936" y="5661248"/>
              <a:ext cx="936104" cy="0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EE4DCB76-10C7-9B82-C136-D5F0D1892E09}"/>
                </a:ext>
              </a:extLst>
            </p:cNvPr>
            <p:cNvCxnSpPr/>
            <p:nvPr/>
          </p:nvCxnSpPr>
          <p:spPr>
            <a:xfrm flipV="1">
              <a:off x="4932040" y="3645024"/>
              <a:ext cx="432048" cy="2016224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5ECE9A4-2805-CBFF-94F5-B176D65DB5A4}"/>
                </a:ext>
              </a:extLst>
            </p:cNvPr>
            <p:cNvCxnSpPr/>
            <p:nvPr/>
          </p:nvCxnSpPr>
          <p:spPr>
            <a:xfrm>
              <a:off x="5364088" y="3645024"/>
              <a:ext cx="1224136" cy="0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76D614A7-A923-2D32-F01E-13E3D8099600}"/>
                </a:ext>
              </a:extLst>
            </p:cNvPr>
            <p:cNvCxnSpPr/>
            <p:nvPr/>
          </p:nvCxnSpPr>
          <p:spPr>
            <a:xfrm>
              <a:off x="6588224" y="3645024"/>
              <a:ext cx="432048" cy="187220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FE950A49-C818-4B10-13E5-1BC33A34EF28}"/>
                </a:ext>
              </a:extLst>
            </p:cNvPr>
            <p:cNvCxnSpPr/>
            <p:nvPr/>
          </p:nvCxnSpPr>
          <p:spPr>
            <a:xfrm flipV="1">
              <a:off x="3979683" y="3429000"/>
              <a:ext cx="0" cy="280831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FA102FEA-81CE-BEAC-789F-FAD3CDA47A28}"/>
                </a:ext>
              </a:extLst>
            </p:cNvPr>
            <p:cNvCxnSpPr/>
            <p:nvPr/>
          </p:nvCxnSpPr>
          <p:spPr>
            <a:xfrm>
              <a:off x="3977689" y="6236999"/>
              <a:ext cx="352839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0">
              <a:extLst>
                <a:ext uri="{FF2B5EF4-FFF2-40B4-BE49-F238E27FC236}">
                  <a16:creationId xmlns:a16="http://schemas.microsoft.com/office/drawing/2014/main" id="{A69A2901-F4E2-A717-7373-22332765164C}"/>
                </a:ext>
              </a:extLst>
            </p:cNvPr>
            <p:cNvSpPr txBox="1"/>
            <p:nvPr/>
          </p:nvSpPr>
          <p:spPr>
            <a:xfrm rot="18349741">
              <a:off x="4212351" y="4413837"/>
              <a:ext cx="1749197" cy="85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Log or exponential phase</a:t>
              </a:r>
            </a:p>
          </p:txBody>
        </p:sp>
        <p:sp>
          <p:nvSpPr>
            <p:cNvPr id="24" name="TextBox 21">
              <a:extLst>
                <a:ext uri="{FF2B5EF4-FFF2-40B4-BE49-F238E27FC236}">
                  <a16:creationId xmlns:a16="http://schemas.microsoft.com/office/drawing/2014/main" id="{E43DB0A0-7EED-6EC8-A7D2-00FCD1C74BBF}"/>
                </a:ext>
              </a:extLst>
            </p:cNvPr>
            <p:cNvSpPr txBox="1"/>
            <p:nvPr/>
          </p:nvSpPr>
          <p:spPr>
            <a:xfrm>
              <a:off x="4047977" y="5350914"/>
              <a:ext cx="8146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Lag phase</a:t>
              </a:r>
              <a:endParaRPr lang="en-IN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2">
              <a:extLst>
                <a:ext uri="{FF2B5EF4-FFF2-40B4-BE49-F238E27FC236}">
                  <a16:creationId xmlns:a16="http://schemas.microsoft.com/office/drawing/2014/main" id="{078F17D3-4CC0-803A-A2A4-DE0FA3CB747E}"/>
                </a:ext>
              </a:extLst>
            </p:cNvPr>
            <p:cNvSpPr txBox="1"/>
            <p:nvPr/>
          </p:nvSpPr>
          <p:spPr>
            <a:xfrm>
              <a:off x="5768798" y="3659327"/>
              <a:ext cx="3926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Stationary phase</a:t>
              </a:r>
              <a:endParaRPr lang="en-IN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3">
              <a:extLst>
                <a:ext uri="{FF2B5EF4-FFF2-40B4-BE49-F238E27FC236}">
                  <a16:creationId xmlns:a16="http://schemas.microsoft.com/office/drawing/2014/main" id="{5160807D-93ED-4C13-96AC-ED7C469EBAA7}"/>
                </a:ext>
              </a:extLst>
            </p:cNvPr>
            <p:cNvSpPr txBox="1"/>
            <p:nvPr/>
          </p:nvSpPr>
          <p:spPr>
            <a:xfrm rot="3079409">
              <a:off x="6393230" y="4437171"/>
              <a:ext cx="942887" cy="85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Death phase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ACA5566D-786E-C717-E1B7-FDA817353B0B}"/>
              </a:ext>
            </a:extLst>
          </p:cNvPr>
          <p:cNvGrpSpPr/>
          <p:nvPr/>
        </p:nvGrpSpPr>
        <p:grpSpPr>
          <a:xfrm>
            <a:off x="3744216" y="3493503"/>
            <a:ext cx="6388897" cy="2818745"/>
            <a:chOff x="4938540" y="499530"/>
            <a:chExt cx="6388897" cy="2818745"/>
          </a:xfrm>
        </p:grpSpPr>
        <p:sp>
          <p:nvSpPr>
            <p:cNvPr id="5" name="Text Box 9">
              <a:extLst>
                <a:ext uri="{FF2B5EF4-FFF2-40B4-BE49-F238E27FC236}">
                  <a16:creationId xmlns:a16="http://schemas.microsoft.com/office/drawing/2014/main" id="{DE903627-CD71-10BD-15B9-FD70FFAD16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38540" y="1311707"/>
              <a:ext cx="824230" cy="10463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85039" tIns="42520" rIns="85039" bIns="42520" numCol="1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sz="12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199 kDa</a:t>
              </a:r>
              <a:endParaRPr kumimoji="0" lang="sv-S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sv-SE" sz="12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sz="12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116 kDa</a:t>
              </a:r>
              <a:endParaRPr kumimoji="0" lang="sv-S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sv-SE" sz="12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sz="12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86 kDa</a:t>
              </a:r>
              <a:endParaRPr kumimoji="0" lang="sv-S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sv-SE" sz="12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sv-SE" sz="1200" dirty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C9C77B4-6AA0-FD74-D2F6-EE7D3C693113}"/>
                </a:ext>
              </a:extLst>
            </p:cNvPr>
            <p:cNvSpPr txBox="1"/>
            <p:nvPr/>
          </p:nvSpPr>
          <p:spPr>
            <a:xfrm rot="19074815">
              <a:off x="6249324" y="3038041"/>
              <a:ext cx="2044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 2, stationary phas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BC99279-49AB-2D1A-5DDB-DBFD8FD827DF}"/>
                </a:ext>
              </a:extLst>
            </p:cNvPr>
            <p:cNvSpPr txBox="1"/>
            <p:nvPr/>
          </p:nvSpPr>
          <p:spPr>
            <a:xfrm rot="19074815">
              <a:off x="5567623" y="2794139"/>
              <a:ext cx="12222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ionary phas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FEF62DB-1D39-FEF9-2C83-8BAF4662D8EF}"/>
                </a:ext>
              </a:extLst>
            </p:cNvPr>
            <p:cNvSpPr txBox="1"/>
            <p:nvPr/>
          </p:nvSpPr>
          <p:spPr>
            <a:xfrm rot="19074815">
              <a:off x="7228260" y="3041276"/>
              <a:ext cx="2036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 2, stationary phas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35688C7-7392-9E72-7ED3-5CDA695FA28E}"/>
                </a:ext>
              </a:extLst>
            </p:cNvPr>
            <p:cNvSpPr txBox="1"/>
            <p:nvPr/>
          </p:nvSpPr>
          <p:spPr>
            <a:xfrm rot="19074815">
              <a:off x="8641507" y="2956253"/>
              <a:ext cx="18199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y1Ac, positive control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324F6ED-2638-EC21-4D23-2E2F45538199}"/>
                </a:ext>
              </a:extLst>
            </p:cNvPr>
            <p:cNvSpPr txBox="1"/>
            <p:nvPr/>
          </p:nvSpPr>
          <p:spPr>
            <a:xfrm rot="19074815">
              <a:off x="8406209" y="2780803"/>
              <a:ext cx="1237697" cy="2847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ionary phas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0731FCF-FACB-FB81-2BB9-B94B4DD4D6F7}"/>
                </a:ext>
              </a:extLst>
            </p:cNvPr>
            <p:cNvSpPr txBox="1"/>
            <p:nvPr/>
          </p:nvSpPr>
          <p:spPr>
            <a:xfrm rot="19074815">
              <a:off x="5858438" y="2927573"/>
              <a:ext cx="161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 2, log phas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DA172E9-2BD9-078C-04A0-33D02C646CEB}"/>
                </a:ext>
              </a:extLst>
            </p:cNvPr>
            <p:cNvSpPr txBox="1"/>
            <p:nvPr/>
          </p:nvSpPr>
          <p:spPr>
            <a:xfrm rot="19074815">
              <a:off x="7098349" y="2919936"/>
              <a:ext cx="1639704" cy="274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 2, log phas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26">
              <a:extLst>
                <a:ext uri="{FF2B5EF4-FFF2-40B4-BE49-F238E27FC236}">
                  <a16:creationId xmlns:a16="http://schemas.microsoft.com/office/drawing/2014/main" id="{D2E98C5C-69E7-4FC1-4E59-8EC20FCEB99B}"/>
                </a:ext>
              </a:extLst>
            </p:cNvPr>
            <p:cNvSpPr txBox="1"/>
            <p:nvPr/>
          </p:nvSpPr>
          <p:spPr>
            <a:xfrm>
              <a:off x="5684489" y="903273"/>
              <a:ext cx="43781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1                2               3                 4             5         6          7           8</a:t>
              </a:r>
              <a:endParaRPr lang="en-IN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46390EA-6D72-5EB4-3A18-50BCD1C863A0}"/>
                </a:ext>
              </a:extLst>
            </p:cNvPr>
            <p:cNvSpPr txBox="1"/>
            <p:nvPr/>
          </p:nvSpPr>
          <p:spPr>
            <a:xfrm>
              <a:off x="10247210" y="1434082"/>
              <a:ext cx="10802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~133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188D70E-98DA-1B5E-F317-9E35DF0D69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20" t="30794" r="38644" b="48163"/>
            <a:stretch/>
          </p:blipFill>
          <p:spPr>
            <a:xfrm>
              <a:off x="5595890" y="1142130"/>
              <a:ext cx="4722787" cy="1443102"/>
            </a:xfrm>
            <a:prstGeom prst="rect">
              <a:avLst/>
            </a:prstGeom>
          </p:spPr>
        </p:pic>
        <p:sp>
          <p:nvSpPr>
            <p:cNvPr id="30" name="Left Brace 29">
              <a:extLst>
                <a:ext uri="{FF2B5EF4-FFF2-40B4-BE49-F238E27FC236}">
                  <a16:creationId xmlns:a16="http://schemas.microsoft.com/office/drawing/2014/main" id="{594E253F-2A2A-B05D-1A15-27963C59354C}"/>
                </a:ext>
              </a:extLst>
            </p:cNvPr>
            <p:cNvSpPr/>
            <p:nvPr/>
          </p:nvSpPr>
          <p:spPr>
            <a:xfrm rot="5400000">
              <a:off x="8660617" y="248409"/>
              <a:ext cx="400606" cy="1339136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903CECC-36E2-6F02-412E-2BD67ECB18E4}"/>
                </a:ext>
              </a:extLst>
            </p:cNvPr>
            <p:cNvSpPr txBox="1"/>
            <p:nvPr/>
          </p:nvSpPr>
          <p:spPr>
            <a:xfrm>
              <a:off x="8405954" y="499531"/>
              <a:ext cx="98514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aerogenes</a:t>
              </a:r>
              <a:endParaRPr lang="en-IN" sz="1200" i="1" dirty="0"/>
            </a:p>
          </p:txBody>
        </p:sp>
        <p:sp>
          <p:nvSpPr>
            <p:cNvPr id="32" name="Left Brace 31">
              <a:extLst>
                <a:ext uri="{FF2B5EF4-FFF2-40B4-BE49-F238E27FC236}">
                  <a16:creationId xmlns:a16="http://schemas.microsoft.com/office/drawing/2014/main" id="{36B19DAB-D5ED-07B6-04EA-F0B49EF5EFC7}"/>
                </a:ext>
              </a:extLst>
            </p:cNvPr>
            <p:cNvSpPr/>
            <p:nvPr/>
          </p:nvSpPr>
          <p:spPr>
            <a:xfrm rot="5400000">
              <a:off x="6829747" y="-129766"/>
              <a:ext cx="404612" cy="2095487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BB24B05-675E-8DB6-0736-DDBCDFCE5A7D}"/>
                </a:ext>
              </a:extLst>
            </p:cNvPr>
            <p:cNvSpPr txBox="1"/>
            <p:nvPr/>
          </p:nvSpPr>
          <p:spPr>
            <a:xfrm>
              <a:off x="6558590" y="499530"/>
              <a:ext cx="98514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coli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12</a:t>
              </a:r>
              <a:endParaRPr lang="en-IN" sz="120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ADE7433-83B5-8EE3-FBD2-C36CC1AE2328}"/>
              </a:ext>
            </a:extLst>
          </p:cNvPr>
          <p:cNvSpPr txBox="1"/>
          <p:nvPr/>
        </p:nvSpPr>
        <p:spPr>
          <a:xfrm>
            <a:off x="0" y="0"/>
            <a:ext cx="834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012EC08-CEA0-1C4A-8B3B-3E2938E61A28}"/>
              </a:ext>
            </a:extLst>
          </p:cNvPr>
          <p:cNvSpPr txBox="1"/>
          <p:nvPr/>
        </p:nvSpPr>
        <p:spPr>
          <a:xfrm>
            <a:off x="101840" y="372860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D5E6A1D-9923-5608-2C76-BCDD8FB9C53A}"/>
              </a:ext>
            </a:extLst>
          </p:cNvPr>
          <p:cNvSpPr txBox="1"/>
          <p:nvPr/>
        </p:nvSpPr>
        <p:spPr>
          <a:xfrm>
            <a:off x="103319" y="38987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9C12E2-84D0-8F1D-55CA-A0622BBA2D03}"/>
              </a:ext>
            </a:extLst>
          </p:cNvPr>
          <p:cNvSpPr txBox="1"/>
          <p:nvPr/>
        </p:nvSpPr>
        <p:spPr>
          <a:xfrm>
            <a:off x="5364266" y="282607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03508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9</TotalTime>
  <Words>66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Ojha</dc:creator>
  <cp:lastModifiedBy>Abhishek Ojha</cp:lastModifiedBy>
  <cp:revision>11</cp:revision>
  <dcterms:created xsi:type="dcterms:W3CDTF">2022-07-17T11:15:08Z</dcterms:created>
  <dcterms:modified xsi:type="dcterms:W3CDTF">2024-12-26T13:36:34Z</dcterms:modified>
</cp:coreProperties>
</file>